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  <p:sldId id="261" r:id="rId6"/>
    <p:sldId id="262" r:id="rId7"/>
    <p:sldId id="263" r:id="rId8"/>
  </p:sldIdLst>
  <p:sldSz cx="14630400" cy="9144000"/>
  <p:notesSz cx="146304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446" y="-653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1052" y="2342515"/>
            <a:ext cx="9078595" cy="158686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2105" y="4231640"/>
            <a:ext cx="7476490" cy="18891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035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0560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035" y="302260"/>
            <a:ext cx="9612630" cy="1209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035" y="1737995"/>
            <a:ext cx="9612630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1438" y="7027545"/>
            <a:ext cx="3417824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035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2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0104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482460" y="123317"/>
            <a:ext cx="166623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Biological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Processes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588530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5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0066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88530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5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620306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1975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620306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52081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569A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52081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83856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8EBB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3856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15632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CCE0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715632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47407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F4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47407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791831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A3A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791831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958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4C4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10958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427339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8427339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 txBox="1"/>
          <p:nvPr/>
        </p:nvSpPr>
        <p:spPr>
          <a:xfrm>
            <a:off x="5943219" y="7763891"/>
            <a:ext cx="2744470" cy="3695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  <a:tabLst>
                <a:tab pos="317500" algn="l"/>
                <a:tab pos="635000" algn="l"/>
                <a:tab pos="953135" algn="l"/>
                <a:tab pos="1270635" algn="l"/>
                <a:tab pos="1588135" algn="l"/>
                <a:tab pos="1906270" algn="l"/>
                <a:tab pos="2223770" algn="l"/>
                <a:tab pos="2541905" algn="l"/>
              </a:tabLst>
            </a:pP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2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2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3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3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4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4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5.0</a:t>
            </a:r>
            <a:endParaRPr sz="10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65"/>
              </a:spcBef>
            </a:pPr>
            <a:r>
              <a:rPr sz="1200" spc="-5" dirty="0">
                <a:latin typeface="Arial"/>
                <a:cs typeface="Arial"/>
              </a:rPr>
              <a:t>Enrichment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core</a:t>
            </a:r>
            <a:endParaRPr sz="1200">
              <a:latin typeface="Arial"/>
              <a:cs typeface="Arial"/>
            </a:endParaRPr>
          </a:p>
        </p:txBody>
      </p:sp>
      <p:graphicFrame>
        <p:nvGraphicFramePr>
          <p:cNvPr id="22" name="object 22"/>
          <p:cNvGraphicFramePr>
            <a:graphicFrameLocks noGrp="1"/>
          </p:cNvGraphicFramePr>
          <p:nvPr/>
        </p:nvGraphicFramePr>
        <p:xfrm>
          <a:off x="170434" y="400431"/>
          <a:ext cx="14324323" cy="703130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837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83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837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8371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8371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8371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98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9789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3495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8542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1970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9017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8762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9433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23190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33350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205105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252094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75565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6032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592455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</a:tblGrid>
              <a:tr h="175869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91135" marR="40005" indent="-143510">
                        <a:lnSpc>
                          <a:spcPct val="116399"/>
                        </a:lnSpc>
                      </a:pP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R)−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−</a:t>
                      </a:r>
                      <a:r>
                        <a:rPr sz="9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yd</a:t>
                      </a:r>
                      <a:r>
                        <a:rPr sz="9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9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xy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−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lpha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−linolenic 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id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iosynthetic</a:t>
                      </a:r>
                      <a:r>
                        <a:rPr sz="9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40005" marR="32384" indent="142240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ysteine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 via</a:t>
                      </a:r>
                      <a:r>
                        <a:rPr sz="11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ystathionin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33782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ron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ssimi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40005" marR="32384" indent="254635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ethylammonium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membrane</a:t>
                      </a:r>
                      <a:r>
                        <a:rPr sz="1100" b="1" spc="-8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154305" marR="146685" indent="-63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egative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  telomere</a:t>
                      </a:r>
                      <a:r>
                        <a:rPr sz="1100" b="1" spc="-9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intenance  via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elomeras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10489">
                        <a:lnSpc>
                          <a:spcPct val="100000"/>
                        </a:lnSpc>
                      </a:pP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parasitic</a:t>
                      </a:r>
                      <a:r>
                        <a:rPr sz="9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ungu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28575">
                        <a:lnSpc>
                          <a:spcPct val="10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ieve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lement</a:t>
                      </a:r>
                      <a:r>
                        <a:rPr sz="11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nucle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8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16839" marR="12065">
                        <a:lnSpc>
                          <a:spcPct val="100000"/>
                        </a:lnSpc>
                      </a:pP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tress response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etal</a:t>
                      </a:r>
                      <a:r>
                        <a:rPr sz="9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67714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279400" marR="272415" indent="118745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ntisense RNA  metabolic</a:t>
                      </a:r>
                      <a:r>
                        <a:rPr sz="1100" b="1" spc="-8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defense response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fungu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4C93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278130" marR="147320" indent="-123189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ron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on import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ross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lasma</a:t>
                      </a:r>
                      <a:r>
                        <a:rPr sz="11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embran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127635" marR="120014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icrotubule</a:t>
                      </a:r>
                      <a:r>
                        <a:rPr sz="11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ucleation  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y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icrotubule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rganizing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enter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194310" marR="79375" indent="-107950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ucleoside</a:t>
                      </a:r>
                      <a:r>
                        <a:rPr sz="1100" b="1" spc="-9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iphosphate  biosynthetic</a:t>
                      </a:r>
                      <a:r>
                        <a:rPr sz="11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57150" marR="48895" indent="191770">
                        <a:lnSpc>
                          <a:spcPct val="120000"/>
                        </a:lnSpc>
                        <a:spcBef>
                          <a:spcPts val="944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tei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ocalization to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urfac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58419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−cell</a:t>
                      </a:r>
                      <a:r>
                        <a:rPr sz="11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ignal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1DA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64795" marR="226695" indent="-31115">
                        <a:lnSpc>
                          <a:spcPct val="120000"/>
                        </a:lnSpc>
                        <a:spcBef>
                          <a:spcPts val="70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jection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elf</a:t>
                      </a:r>
                      <a:r>
                        <a:rPr sz="1100" b="1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olle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0EC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8255" marR="12065">
                        <a:lnSpc>
                          <a:spcPct val="10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lipid</a:t>
                      </a:r>
                      <a:r>
                        <a:rPr sz="11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4175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314960" marR="61594" indent="-246379">
                        <a:lnSpc>
                          <a:spcPct val="123100"/>
                        </a:lnSpc>
                        <a:spcBef>
                          <a:spcPts val="590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calcium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−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ediated  signaling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5">
                  <a:txBody>
                    <a:bodyPr/>
                    <a:lstStyle/>
                    <a:p>
                      <a:pPr marR="21590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21590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21590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21590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650">
                        <a:latin typeface="Times New Roman"/>
                        <a:cs typeface="Times New Roman"/>
                      </a:endParaRPr>
                    </a:p>
                    <a:p>
                      <a:pPr marL="24130" marR="60325" algn="ctr">
                        <a:lnSpc>
                          <a:spcPct val="112200"/>
                        </a:lnSpc>
                        <a:spcBef>
                          <a:spcPts val="5"/>
                        </a:spcBef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modification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−dependent 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rotein catabolic  process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1DA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4445" marR="20955" algn="ctr">
                        <a:lnSpc>
                          <a:spcPct val="114399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response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to     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mmonium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ion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35560" marR="54610" algn="ctr">
                        <a:lnSpc>
                          <a:spcPct val="117500"/>
                        </a:lnSpc>
                        <a:spcBef>
                          <a:spcPts val="465"/>
                        </a:spcBef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endopeptidase  activity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680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5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5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1D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6381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0569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9EC4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255904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oubl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5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1D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8611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26035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iological_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0569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granum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assembl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299085" marR="290830" indent="130810">
                        <a:lnSpc>
                          <a:spcPct val="120000"/>
                        </a:lnSpc>
                        <a:spcBef>
                          <a:spcPts val="72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killing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s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other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organism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914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9EC4FF"/>
                    </a:solidFill>
                  </a:tcPr>
                </a:tc>
                <a:tc>
                  <a:txBody>
                    <a:bodyPr/>
                    <a:lstStyle/>
                    <a:p>
                      <a:pPr marL="199390" marR="120014" indent="-71755">
                        <a:lnSpc>
                          <a:spcPct val="120000"/>
                        </a:lnSpc>
                        <a:spcBef>
                          <a:spcPts val="720"/>
                        </a:spcBef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icrotubule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ucleation  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y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pindle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ole</a:t>
                      </a:r>
                      <a:r>
                        <a:rPr sz="11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od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914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262255" marR="254635" algn="ctr">
                        <a:lnSpc>
                          <a:spcPts val="1580"/>
                        </a:lnSpc>
                        <a:spcBef>
                          <a:spcPts val="3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hosphorylated 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arbohydrat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phospho</a:t>
                      </a:r>
                      <a:r>
                        <a:rPr sz="1100" b="1" spc="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y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165735" marR="158115" indent="50800">
                        <a:lnSpc>
                          <a:spcPts val="158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fertilization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forming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a  zygote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nd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ndosperm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46355" marR="38735" indent="78105">
                        <a:lnSpc>
                          <a:spcPct val="120600"/>
                        </a:lnSpc>
                        <a:spcBef>
                          <a:spcPts val="73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sponse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o  biotic</a:t>
                      </a:r>
                      <a:r>
                        <a:rPr sz="9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stimulu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A8CAFF"/>
                    </a:solidFill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25400" marR="17780" indent="-635" algn="ctr">
                        <a:lnSpc>
                          <a:spcPct val="11610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mino  acid</a:t>
                      </a:r>
                      <a:r>
                        <a:rPr sz="10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export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94615" marR="13970" indent="-73025">
                        <a:lnSpc>
                          <a:spcPct val="119400"/>
                        </a:lnSpc>
                        <a:spcBef>
                          <a:spcPts val="770"/>
                        </a:spcBef>
                      </a:pPr>
                      <a:r>
                        <a:rPr sz="900" b="1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leosome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assembl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4790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13970" marR="6350" algn="ctr">
                        <a:lnSpc>
                          <a:spcPct val="113599"/>
                        </a:lnSpc>
                        <a:spcBef>
                          <a:spcPts val="5"/>
                        </a:spcBef>
                      </a:pPr>
                      <a:r>
                        <a:rPr sz="7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arbo</a:t>
                      </a:r>
                      <a:r>
                        <a:rPr sz="7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</a:t>
                      </a:r>
                      <a:r>
                        <a:rPr sz="7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ydrate  metabolic  process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0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12065" algn="ctr">
                        <a:lnSpc>
                          <a:spcPts val="1015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cellular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750" marR="43180" algn="ctr">
                        <a:lnSpc>
                          <a:spcPct val="126099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sponse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o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iron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D6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379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0569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9EC4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3335" marR="12065">
                        <a:lnSpc>
                          <a:spcPts val="955"/>
                        </a:lnSpc>
                      </a:pPr>
                      <a:r>
                        <a:rPr sz="900" b="1" spc="-10" dirty="0">
                          <a:latin typeface="Arial"/>
                          <a:cs typeface="Arial"/>
                        </a:rPr>
                        <a:t>starv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1500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0569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9EC4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203835">
                        <a:lnSpc>
                          <a:spcPts val="1175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rowSpan="4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80010" marR="72390" indent="-635" algn="ctr">
                        <a:lnSpc>
                          <a:spcPct val="1177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spindle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pole</a:t>
                      </a:r>
                      <a:r>
                        <a:rPr sz="8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body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7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organiz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19685" marR="12065" indent="137160">
                        <a:lnSpc>
                          <a:spcPct val="118000"/>
                        </a:lnSpc>
                        <a:spcBef>
                          <a:spcPts val="48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system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developmen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7FB2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A6C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473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056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4B5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866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84B5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52705">
                        <a:lnSpc>
                          <a:spcPct val="100000"/>
                        </a:lnSpc>
                        <a:spcBef>
                          <a:spcPts val="8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</a:t>
                      </a:r>
                      <a:r>
                        <a:rPr sz="1100" b="1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01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66A3FF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marL="64769">
                        <a:lnSpc>
                          <a:spcPts val="117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sucros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7FB2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marL="5080" marR="12065">
                        <a:lnSpc>
                          <a:spcPts val="117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0A6C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30263"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23431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balt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on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08585">
                        <a:lnSpc>
                          <a:spcPct val="100000"/>
                        </a:lnSpc>
                      </a:pP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nactivation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 MAPK</a:t>
                      </a:r>
                      <a:r>
                        <a:rPr sz="9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tivit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74295">
                        <a:lnSpc>
                          <a:spcPct val="100000"/>
                        </a:lnSpc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nnan metabolic</a:t>
                      </a:r>
                      <a:r>
                        <a:rPr sz="10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239395" marR="158115" indent="-73660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egative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</a:t>
                      </a:r>
                      <a:r>
                        <a:rPr sz="1100" b="1" spc="-9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  MAP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kinase</a:t>
                      </a:r>
                      <a:r>
                        <a:rPr sz="1100" b="1" spc="-5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tiv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78740">
                        <a:lnSpc>
                          <a:spcPct val="100000"/>
                        </a:lnSpc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</a:t>
                      </a:r>
                      <a:r>
                        <a:rPr sz="10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</a:t>
                      </a:r>
                      <a:r>
                        <a:rPr sz="10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ydroperoxide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marL="107314" marR="19685" indent="-80010">
                        <a:lnSpc>
                          <a:spcPct val="120000"/>
                        </a:lnSpc>
                        <a:spcBef>
                          <a:spcPts val="39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oubl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fertilization</a:t>
                      </a:r>
                      <a:r>
                        <a:rPr sz="11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forming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a zygote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nd</a:t>
                      </a:r>
                      <a:r>
                        <a:rPr sz="11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ndosperm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01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4B5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69545">
                        <a:lnSpc>
                          <a:spcPts val="129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nitrogen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115570">
                        <a:lnSpc>
                          <a:spcPts val="1000"/>
                        </a:lnSpc>
                        <a:spcBef>
                          <a:spcPts val="210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starv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marL="22860">
                        <a:lnSpc>
                          <a:spcPts val="111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marL="48260" marR="12065">
                        <a:lnSpc>
                          <a:spcPts val="111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</a:t>
                      </a:r>
                      <a:r>
                        <a:rPr sz="11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uxi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6532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1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4B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>
                  <a:txBody>
                    <a:bodyPr/>
                    <a:lstStyle/>
                    <a:p>
                      <a:pPr marL="41910" marR="35560" algn="ctr">
                        <a:lnSpc>
                          <a:spcPct val="114500"/>
                        </a:lnSpc>
                        <a:spcBef>
                          <a:spcPts val="71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cell−cell  signaling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involved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in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cell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fate</a:t>
                      </a:r>
                      <a:r>
                        <a:rPr sz="8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commitmen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901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rowSpan="3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123189" marR="18415" indent="-97790">
                        <a:lnSpc>
                          <a:spcPct val="124200"/>
                        </a:lnSpc>
                        <a:spcBef>
                          <a:spcPts val="505"/>
                        </a:spcBef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mito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hondrial  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pyruvate 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transport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41910" marR="46355" algn="ctr">
                        <a:lnSpc>
                          <a:spcPct val="121900"/>
                        </a:lnSpc>
                        <a:spcBef>
                          <a:spcPts val="24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response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to   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symbiotic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fungus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3111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marL="31115" indent="146685">
                        <a:lnSpc>
                          <a:spcPct val="114399"/>
                        </a:lnSpc>
                        <a:spcBef>
                          <a:spcPts val="50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cell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fate  determin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63500" marB="0"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 marL="97790" marR="67310" indent="-33655">
                        <a:lnSpc>
                          <a:spcPct val="123300"/>
                        </a:lnSpc>
                        <a:spcBef>
                          <a:spcPts val="375"/>
                        </a:spcBef>
                      </a:pPr>
                      <a:r>
                        <a:rPr sz="8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ytoplasmic  </a:t>
                      </a:r>
                      <a:r>
                        <a:rPr sz="8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l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4762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5638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1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4B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01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11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 marL="148590" marR="116205" indent="5080">
                        <a:lnSpc>
                          <a:spcPct val="120000"/>
                        </a:lnSpc>
                        <a:spcBef>
                          <a:spcPts val="15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nitrate  impo</a:t>
                      </a:r>
                      <a:r>
                        <a:rPr sz="1100" b="1" spc="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114300" marR="12065">
                        <a:lnSpc>
                          <a:spcPts val="1075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mannan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marL="115570" marR="84455" indent="-33020">
                        <a:lnSpc>
                          <a:spcPct val="1149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488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333375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fense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01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11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221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21590" marR="13335" indent="120014">
                        <a:lnSpc>
                          <a:spcPct val="120000"/>
                        </a:lnSpc>
                        <a:spcBef>
                          <a:spcPts val="98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fatty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i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homeosta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509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8A8"/>
                    </a:solidFill>
                  </a:tcPr>
                </a:tc>
                <a:tc rowSpan="2" gridSpan="3">
                  <a:txBody>
                    <a:bodyPr/>
                    <a:lstStyle/>
                    <a:p>
                      <a:pPr marL="27305" marR="19685" algn="ctr">
                        <a:lnSpc>
                          <a:spcPts val="1300"/>
                        </a:lnSpc>
                        <a:spcBef>
                          <a:spcPts val="3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sponse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o    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nitrogen  compound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3">
                  <a:txBody>
                    <a:bodyPr/>
                    <a:lstStyle/>
                    <a:p>
                      <a:pPr marR="21590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2159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94615" marR="99695" algn="ctr">
                        <a:lnSpc>
                          <a:spcPct val="113199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600" b="1" spc="-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leaf</a:t>
                      </a:r>
                      <a:endParaRPr sz="6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95"/>
                        </a:spcBef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morpho</a:t>
                      </a:r>
                      <a:r>
                        <a:rPr sz="600" b="1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enesis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0A9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7614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509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8A8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0A9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53975" marR="22225" indent="26034">
                        <a:lnSpc>
                          <a:spcPct val="115700"/>
                        </a:lnSpc>
                        <a:spcBef>
                          <a:spcPts val="5"/>
                        </a:spcBef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actin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filament  po</a:t>
                      </a:r>
                      <a:r>
                        <a:rPr sz="700" b="1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ymerization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254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indent="232410">
                        <a:lnSpc>
                          <a:spcPct val="110300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protein  geranylgeranylation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24" name="Rettangolo 23"/>
          <p:cNvSpPr/>
          <p:nvPr/>
        </p:nvSpPr>
        <p:spPr>
          <a:xfrm>
            <a:off x="12496800" y="8305800"/>
            <a:ext cx="3200400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 A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482460" y="123317"/>
            <a:ext cx="166623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Biological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Processes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6870318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0066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6870318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6997445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3887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6997445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7124572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89B8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7124572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7251700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DBE9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7251700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378700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CC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7378700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505827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75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505827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632954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191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632954" y="7687564"/>
            <a:ext cx="127635" cy="97790"/>
          </a:xfrm>
          <a:custGeom>
            <a:avLst/>
            <a:gdLst/>
            <a:ahLst/>
            <a:cxnLst/>
            <a:rect l="l" t="t" r="r" b="b"/>
            <a:pathLst>
              <a:path w="127634" h="97790">
                <a:moveTo>
                  <a:pt x="0" y="97282"/>
                </a:moveTo>
                <a:lnTo>
                  <a:pt x="127126" y="97282"/>
                </a:lnTo>
                <a:lnTo>
                  <a:pt x="127126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 txBox="1"/>
          <p:nvPr/>
        </p:nvSpPr>
        <p:spPr>
          <a:xfrm>
            <a:off x="6708520" y="7763891"/>
            <a:ext cx="1213485" cy="3695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1</a:t>
            </a:r>
            <a:r>
              <a:rPr sz="1000" spc="150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2</a:t>
            </a:r>
            <a:r>
              <a:rPr sz="1000" spc="150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3</a:t>
            </a:r>
            <a:r>
              <a:rPr sz="1000" spc="155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4</a:t>
            </a:r>
            <a:r>
              <a:rPr sz="1000" spc="150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5</a:t>
            </a:r>
            <a:r>
              <a:rPr sz="1000" spc="155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6</a:t>
            </a:r>
            <a:r>
              <a:rPr sz="1000" spc="150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7</a:t>
            </a:r>
            <a:endParaRPr sz="10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65"/>
              </a:spcBef>
            </a:pPr>
            <a:r>
              <a:rPr sz="1200" spc="-5" dirty="0">
                <a:latin typeface="Arial"/>
                <a:cs typeface="Arial"/>
              </a:rPr>
              <a:t>Enrichment</a:t>
            </a:r>
            <a:r>
              <a:rPr sz="1200" spc="-5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core</a:t>
            </a:r>
            <a:endParaRPr sz="1200">
              <a:latin typeface="Arial"/>
              <a:cs typeface="Arial"/>
            </a:endParaRPr>
          </a:p>
        </p:txBody>
      </p:sp>
      <p:graphicFrame>
        <p:nvGraphicFramePr>
          <p:cNvPr id="18" name="object 18"/>
          <p:cNvGraphicFramePr>
            <a:graphicFrameLocks noGrp="1"/>
          </p:cNvGraphicFramePr>
          <p:nvPr/>
        </p:nvGraphicFramePr>
        <p:xfrm>
          <a:off x="170434" y="400558"/>
          <a:ext cx="14276701" cy="70987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73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73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973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9730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227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1569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0266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5694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9683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91694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7566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32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72516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10819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932180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985075"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78105" marR="69215" indent="157480">
                        <a:lnSpc>
                          <a:spcPct val="122800"/>
                        </a:lnSpc>
                      </a:pP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−)−pinoresinol  biosynthetic</a:t>
                      </a:r>
                      <a:r>
                        <a:rPr sz="900" b="1" spc="-8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1082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VT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athwa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8763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cromitophag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205740" marR="198755" indent="19050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ell</a:t>
                      </a:r>
                      <a:r>
                        <a:rPr sz="11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dhes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68910" marR="161925" indent="90170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UV−damage 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xcision</a:t>
                      </a:r>
                      <a:r>
                        <a:rPr sz="1100" b="1" spc="-6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pair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505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8575">
                        <a:lnSpc>
                          <a:spcPct val="100000"/>
                        </a:lnSpc>
                        <a:spcBef>
                          <a:spcPts val="97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mide</a:t>
                      </a:r>
                      <a:r>
                        <a:rPr sz="1100" b="1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78105" marR="88265" indent="146050">
                        <a:lnSpc>
                          <a:spcPct val="120000"/>
                        </a:lnSpc>
                        <a:spcBef>
                          <a:spcPts val="85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ell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wall  o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49530" marR="41910" algn="ctr">
                        <a:lnSpc>
                          <a:spcPct val="122600"/>
                        </a:lnSpc>
                        <a:spcBef>
                          <a:spcPts val="69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otassium ion  transmembrane  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35255" marR="48260" indent="-78740">
                        <a:lnSpc>
                          <a:spcPct val="120200"/>
                        </a:lnSpc>
                        <a:spcBef>
                          <a:spcPts val="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brassinoste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id  homeostasi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99060">
                        <a:lnSpc>
                          <a:spcPct val="100000"/>
                        </a:lnSpc>
                        <a:spcBef>
                          <a:spcPts val="6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bsciss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52705" marR="23495" indent="-635" algn="ctr">
                        <a:lnSpc>
                          <a:spcPct val="1186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nion</a:t>
                      </a:r>
                      <a:r>
                        <a:rPr sz="10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channel  activity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97485" marR="20320" indent="-150495">
                        <a:lnSpc>
                          <a:spcPct val="117100"/>
                        </a:lnSpc>
                      </a:pPr>
                      <a:r>
                        <a:rPr sz="10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otassium</a:t>
                      </a:r>
                      <a:r>
                        <a:rPr sz="1000" b="1" spc="-10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on  transport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D81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58419" marR="43180" indent="-635" algn="ctr">
                        <a:lnSpc>
                          <a:spcPct val="120000"/>
                        </a:lnSpc>
                        <a:spcBef>
                          <a:spcPts val="53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ndoleac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i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73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8255" marR="3175"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folic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marL="15240" marR="9525" algn="ctr">
                        <a:lnSpc>
                          <a:spcPct val="1220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acid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−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containing  compound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82550" marR="75565" algn="ctr">
                        <a:lnSpc>
                          <a:spcPct val="120000"/>
                        </a:lnSpc>
                        <a:spcBef>
                          <a:spcPts val="96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  response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opper</a:t>
                      </a:r>
                      <a:r>
                        <a:rPr sz="1100" b="1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192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30480" marR="68580" indent="-635" algn="ctr">
                        <a:lnSpc>
                          <a:spcPct val="11800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cellular  response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to  potassium</a:t>
                      </a:r>
                      <a:r>
                        <a:rPr sz="1000" b="1" spc="-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ion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>
                  <a:txBody>
                    <a:bodyPr/>
                    <a:lstStyle/>
                    <a:p>
                      <a:pPr marR="38100" algn="ctr">
                        <a:lnSpc>
                          <a:spcPct val="120000"/>
                        </a:lnSpc>
                        <a:spcBef>
                          <a:spcPts val="96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OPI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oating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Golgi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vesicl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marL="28575" marR="45720" indent="-635" algn="ctr">
                        <a:lnSpc>
                          <a:spcPct val="120000"/>
                        </a:lnSpc>
                        <a:spcBef>
                          <a:spcPts val="96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Golgi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lcium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  homeosta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26670" marR="12065" indent="-26034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Golgi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lcium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</a:t>
                      </a:r>
                      <a:r>
                        <a:rPr sz="1100" b="1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>
                  <a:txBody>
                    <a:bodyPr/>
                    <a:lstStyle/>
                    <a:p>
                      <a:pPr marL="55880" marR="55880" algn="ctr">
                        <a:lnSpc>
                          <a:spcPct val="120000"/>
                        </a:lnSpc>
                        <a:spcBef>
                          <a:spcPts val="17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nte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pecies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nteraction  between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organism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215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909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83820" marR="7683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sesquiterpen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6153"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180975" marR="173355" indent="43815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idic amino  acid</a:t>
                      </a:r>
                      <a:r>
                        <a:rPr sz="1100" b="1" spc="-7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151130" marR="144145" indent="232410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 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ovo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translational  protein</a:t>
                      </a:r>
                      <a:r>
                        <a:rPr sz="11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old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83515" marR="175260" indent="-635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le−femal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gamete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cognition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uring</a:t>
                      </a:r>
                      <a:r>
                        <a:rPr sz="11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ouble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fertil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308610" marR="75565" indent="-225425">
                        <a:lnSpc>
                          <a:spcPct val="123900"/>
                        </a:lnSpc>
                      </a:pP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</a:t>
                      </a:r>
                      <a:r>
                        <a:rPr sz="9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istone  </a:t>
                      </a: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odific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358140" marR="350520" algn="ctr">
                        <a:lnSpc>
                          <a:spcPct val="120000"/>
                        </a:lnSpc>
                        <a:spcBef>
                          <a:spcPts val="94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eptid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19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856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7AAF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25400" marR="19050" algn="ctr">
                        <a:lnSpc>
                          <a:spcPct val="114399"/>
                        </a:lnSpc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phosphate−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containing  compound</a:t>
                      </a:r>
                      <a:endParaRPr sz="700">
                        <a:latin typeface="Arial"/>
                        <a:cs typeface="Arial"/>
                      </a:endParaRPr>
                    </a:p>
                    <a:p>
                      <a:pPr marL="8255" marR="3175" algn="ctr">
                        <a:lnSpc>
                          <a:spcPct val="100000"/>
                        </a:lnSpc>
                        <a:spcBef>
                          <a:spcPts val="120"/>
                        </a:spcBef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metabolic</a:t>
                      </a:r>
                      <a:r>
                        <a:rPr sz="7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82550" marR="39370" algn="ctr">
                        <a:lnSpc>
                          <a:spcPct val="120000"/>
                        </a:lnSpc>
                        <a:spcBef>
                          <a:spcPts val="86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L−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rabinose  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098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E0E0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156210" marR="129539" algn="ctr">
                        <a:lnSpc>
                          <a:spcPct val="120000"/>
                        </a:lnSpc>
                        <a:spcBef>
                          <a:spcPts val="229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si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TORC1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18415" algn="ctr">
                        <a:lnSpc>
                          <a:spcPct val="100000"/>
                        </a:lnSpc>
                        <a:spcBef>
                          <a:spcPts val="2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signal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2920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550">
                        <a:latin typeface="Times New Roman"/>
                        <a:cs typeface="Times New Roman"/>
                      </a:endParaRPr>
                    </a:p>
                    <a:p>
                      <a:pPr marL="140970" marR="134620" indent="8128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un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ld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marL="33020" marR="14604" indent="-635" algn="ctr">
                        <a:lnSpc>
                          <a:spcPct val="1171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autoph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gosome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assembl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39370" marR="27940" indent="-1270" algn="ctr">
                        <a:lnSpc>
                          <a:spcPct val="1170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of  potassium</a:t>
                      </a:r>
                      <a:r>
                        <a:rPr sz="1000" b="1" spc="-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ion  transport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27305" marR="20320" indent="-635" algn="ctr">
                        <a:lnSpc>
                          <a:spcPct val="116799"/>
                        </a:lnSpc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proteasomal 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ubiquitin−dependent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protein catabolic  process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3219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marL="33655" marR="26034" indent="-63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oligopeptide  transmembrane  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19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98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920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163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5715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trichome</a:t>
                      </a:r>
                      <a:r>
                        <a:rPr sz="11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attern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19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98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920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48424"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28575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denosine</a:t>
                      </a:r>
                      <a:r>
                        <a:rPr sz="11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alvag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233045" marR="168275" indent="-57150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guard cell</a:t>
                      </a:r>
                      <a:r>
                        <a:rPr sz="1100" b="1" spc="-9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ate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mmit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20650" indent="-113030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egative</a:t>
                      </a:r>
                      <a:r>
                        <a:rPr sz="11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si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116839" marR="109220" indent="-127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f  nematode</a:t>
                      </a:r>
                      <a:r>
                        <a:rPr sz="1100" b="1" spc="-9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larval 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196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5715" algn="ctr">
                        <a:lnSpc>
                          <a:spcPct val="120000"/>
                        </a:lnSpc>
                        <a:spcBef>
                          <a:spcPts val="58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urin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ibo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eoside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salvag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736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45720" marR="3175" algn="ctr">
                        <a:lnSpc>
                          <a:spcPct val="120000"/>
                        </a:lnSpc>
                        <a:spcBef>
                          <a:spcPts val="37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eiotic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ister  chromatid  cohes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469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E0E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85090" marR="13335" indent="34925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ion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tr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11125" marR="5715" indent="275590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leaf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enescenc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 marL="184150">
                        <a:lnSpc>
                          <a:spcPct val="100000"/>
                        </a:lnSpc>
                        <a:spcBef>
                          <a:spcPts val="1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203835" marR="57785" indent="-30480" algn="just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efense  respon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1100" b="1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fungu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7780" marB="0"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2">
                  <a:txBody>
                    <a:bodyPr/>
                    <a:lstStyle/>
                    <a:p>
                      <a:pPr marL="67945" algn="ctr">
                        <a:lnSpc>
                          <a:spcPct val="100000"/>
                        </a:lnSpc>
                        <a:spcBef>
                          <a:spcPts val="1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75565" indent="-63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angane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    homeosta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778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76200" marR="13970" indent="-33655">
                        <a:lnSpc>
                          <a:spcPct val="116500"/>
                        </a:lnSpc>
                        <a:spcBef>
                          <a:spcPts val="535"/>
                        </a:spcBef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phosphati</a:t>
                      </a:r>
                      <a:r>
                        <a:rPr sz="700" b="1" spc="-15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ylinositol  dephosphorylation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8939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50825" marR="8890" indent="-234950">
                        <a:lnSpc>
                          <a:spcPct val="120000"/>
                        </a:lnSpc>
                        <a:spcBef>
                          <a:spcPts val="96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sister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hromatid  cohes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36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69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54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7780" marB="0"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778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476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104775" marR="98425" algn="ctr">
                        <a:lnSpc>
                          <a:spcPct val="120000"/>
                        </a:lnSpc>
                        <a:spcBef>
                          <a:spcPts val="15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efense  response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bacterium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5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500">
                        <a:latin typeface="Times New Roman"/>
                        <a:cs typeface="Times New Roman"/>
                      </a:endParaRPr>
                    </a:p>
                    <a:p>
                      <a:pPr marL="224790" marR="180975" indent="-635" algn="ctr">
                        <a:lnSpc>
                          <a:spcPct val="123200"/>
                        </a:lnSpc>
                        <a:spcBef>
                          <a:spcPts val="375"/>
                        </a:spcBef>
                      </a:pPr>
                      <a:r>
                        <a:rPr sz="500" b="1" spc="-5" dirty="0">
                          <a:latin typeface="Arial"/>
                          <a:cs typeface="Arial"/>
                        </a:rPr>
                        <a:t>molybdenum  </a:t>
                      </a:r>
                      <a:r>
                        <a:rPr sz="500" b="1" dirty="0">
                          <a:latin typeface="Arial"/>
                          <a:cs typeface="Arial"/>
                        </a:rPr>
                        <a:t>incorporation into</a:t>
                      </a:r>
                      <a:endParaRPr sz="500">
                        <a:latin typeface="Arial"/>
                        <a:cs typeface="Arial"/>
                      </a:endParaRPr>
                    </a:p>
                    <a:p>
                      <a:pPr marL="60960" marR="17780" algn="ctr">
                        <a:lnSpc>
                          <a:spcPct val="123200"/>
                        </a:lnSpc>
                      </a:pPr>
                      <a:r>
                        <a:rPr sz="500" b="1" spc="-5" dirty="0">
                          <a:latin typeface="Arial"/>
                          <a:cs typeface="Arial"/>
                        </a:rPr>
                        <a:t>mo</a:t>
                      </a:r>
                      <a:r>
                        <a:rPr sz="500" b="1" spc="-1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500" b="1" spc="-5" dirty="0">
                          <a:latin typeface="Arial"/>
                          <a:cs typeface="Arial"/>
                        </a:rPr>
                        <a:t>ybde</a:t>
                      </a:r>
                      <a:r>
                        <a:rPr sz="500" b="1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500" b="1" dirty="0">
                          <a:latin typeface="Arial"/>
                          <a:cs typeface="Arial"/>
                        </a:rPr>
                        <a:t>um−</a:t>
                      </a:r>
                      <a:r>
                        <a:rPr sz="500" b="1" spc="-5" dirty="0">
                          <a:latin typeface="Arial"/>
                          <a:cs typeface="Arial"/>
                        </a:rPr>
                        <a:t>mo</a:t>
                      </a:r>
                      <a:r>
                        <a:rPr sz="500" b="1" spc="-1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500" b="1" spc="-5" dirty="0">
                          <a:latin typeface="Arial"/>
                          <a:cs typeface="Arial"/>
                        </a:rPr>
                        <a:t>ybdopterin  complex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71120" indent="-635" algn="ctr">
                        <a:lnSpc>
                          <a:spcPct val="113500"/>
                        </a:lnSpc>
                        <a:spcBef>
                          <a:spcPts val="56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spermidine  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yd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800" b="1" spc="-2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xycinnamate  conjugate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55244" indent="-635" algn="ctr">
                        <a:lnSpc>
                          <a:spcPct val="113599"/>
                        </a:lnSpc>
                      </a:pP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rug   transmembrane  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D81FF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 marL="22225" algn="ctr">
                        <a:lnSpc>
                          <a:spcPts val="99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5S class</a:t>
                      </a:r>
                      <a:r>
                        <a:rPr sz="900" b="1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RNA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48895" marR="18415" indent="-635" algn="ctr">
                        <a:lnSpc>
                          <a:spcPct val="1232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transcription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from RNA  polymerase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III  type 1</a:t>
                      </a:r>
                      <a:r>
                        <a:rPr sz="9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promoter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4769" marR="47625" algn="ctr">
                        <a:lnSpc>
                          <a:spcPct val="1195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GDP−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annose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44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>
                  <a:txBody>
                    <a:bodyPr/>
                    <a:lstStyle/>
                    <a:p>
                      <a:pPr marL="52705" marR="43180" indent="-635" algn="ctr">
                        <a:lnSpc>
                          <a:spcPct val="120000"/>
                        </a:lnSpc>
                        <a:spcBef>
                          <a:spcPts val="59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lastid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mbran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755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898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6510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ignal</a:t>
                      </a:r>
                      <a:r>
                        <a:rPr sz="1100" b="1" spc="-7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duc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17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D81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55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6369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30810" marR="76200" indent="-46990">
                        <a:lnSpc>
                          <a:spcPct val="120000"/>
                        </a:lnSpc>
                        <a:spcBef>
                          <a:spcPts val="78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tassium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  homeosta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17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D81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55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5046"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4508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mino acid</a:t>
                      </a:r>
                      <a:r>
                        <a:rPr sz="11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m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49554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MP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salvag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236854" marR="229235" indent="-635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olyketid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77470">
                        <a:lnSpc>
                          <a:spcPct val="100000"/>
                        </a:lnSpc>
                      </a:pPr>
                      <a:r>
                        <a:rPr sz="9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</a:t>
                      </a: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</a:t>
                      </a:r>
                      <a:r>
                        <a:rPr sz="9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ytokine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175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D81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556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64484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73660" marR="67310" algn="ctr">
                        <a:lnSpc>
                          <a:spcPct val="120000"/>
                        </a:lnSpc>
                        <a:spcBef>
                          <a:spcPts val="38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ranscription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from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NA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polymera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II</a:t>
                      </a:r>
                      <a:r>
                        <a:rPr sz="11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moter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482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marL="113664" marR="35560" indent="-34290">
                        <a:lnSpc>
                          <a:spcPct val="12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nuclear</a:t>
                      </a:r>
                      <a:r>
                        <a:rPr sz="11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or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istribu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4160" marR="15240" indent="-177165">
                        <a:lnSpc>
                          <a:spcPct val="123200"/>
                        </a:lnSpc>
                        <a:spcBef>
                          <a:spcPts val="5"/>
                        </a:spcBef>
                      </a:pP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membrane  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57785" algn="ctr">
                        <a:lnSpc>
                          <a:spcPct val="116300"/>
                        </a:lnSpc>
                        <a:spcBef>
                          <a:spcPts val="550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stomatal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complex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orpho</a:t>
                      </a:r>
                      <a:r>
                        <a:rPr sz="900" b="1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enesi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9C1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123825" marR="85725" indent="-17145" algn="just">
                        <a:lnSpc>
                          <a:spcPct val="120000"/>
                        </a:lnSpc>
                        <a:spcBef>
                          <a:spcPts val="61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tein  stabil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7747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66675" marR="62230" indent="-83185">
                        <a:lnSpc>
                          <a:spcPct val="120300"/>
                        </a:lnSpc>
                        <a:spcBef>
                          <a:spcPts val="59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UDP−L−arabinose  etabolic</a:t>
                      </a:r>
                      <a:r>
                        <a:rPr sz="8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R="24765" algn="ctr">
                        <a:lnSpc>
                          <a:spcPct val="100000"/>
                        </a:lnSpc>
                        <a:spcBef>
                          <a:spcPts val="509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UTP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38100" marR="6286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476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785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67945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fense</a:t>
                      </a:r>
                      <a:r>
                        <a:rPr sz="11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rowSpan="5">
                  <a:txBody>
                    <a:bodyPr/>
                    <a:lstStyle/>
                    <a:p>
                      <a:pPr marL="95885" marR="88265" algn="ctr">
                        <a:lnSpc>
                          <a:spcPct val="120000"/>
                        </a:lnSpc>
                        <a:spcBef>
                          <a:spcPts val="53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nositol  trisphosphat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73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82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9C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747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476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90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73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82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9C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747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BCD7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9209" marR="82550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ectin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algn="ctr">
                        <a:lnSpc>
                          <a:spcPts val="780"/>
                        </a:lnSpc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negative</a:t>
                      </a:r>
                      <a:endParaRPr sz="700">
                        <a:latin typeface="Arial"/>
                        <a:cs typeface="Arial"/>
                      </a:endParaRPr>
                    </a:p>
                    <a:p>
                      <a:pPr marL="321945" marR="314325" indent="-635" algn="ctr">
                        <a:lnSpc>
                          <a:spcPct val="123800"/>
                        </a:lnSpc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700" b="1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long−day</a:t>
                      </a:r>
                      <a:endParaRPr sz="700">
                        <a:latin typeface="Arial"/>
                        <a:cs typeface="Arial"/>
                      </a:endParaRPr>
                    </a:p>
                    <a:p>
                      <a:pPr marL="223520" marR="215900" algn="ctr">
                        <a:lnSpc>
                          <a:spcPct val="123900"/>
                        </a:lnSpc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photoperiodism,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flowering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901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73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8255" marR="3175"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MP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88900" marR="82550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61594" marR="17780" algn="ctr">
                        <a:lnSpc>
                          <a:spcPct val="1213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oligosac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haride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190500" marR="118110" algn="ctr">
                        <a:lnSpc>
                          <a:spcPct val="120000"/>
                        </a:lnSpc>
                        <a:spcBef>
                          <a:spcPts val="919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valin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1683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72390" marR="13335" indent="-635" algn="ctr">
                        <a:lnSpc>
                          <a:spcPct val="120000"/>
                        </a:lnSpc>
                        <a:spcBef>
                          <a:spcPts val="86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erpenoid  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092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3810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73660" marR="82550" indent="-3048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RNA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5−end  pr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8280"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84150" marR="176530" indent="-635" algn="ctr">
                        <a:lnSpc>
                          <a:spcPct val="120000"/>
                        </a:lnSpc>
                        <a:spcBef>
                          <a:spcPts val="93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ell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wall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nnop</a:t>
                      </a:r>
                      <a:r>
                        <a:rPr sz="11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otein  biosynthetic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321945" marR="314960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leucine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68910" marR="161290" indent="-635" algn="ctr">
                        <a:lnSpc>
                          <a:spcPct val="120000"/>
                        </a:lnSpc>
                        <a:spcBef>
                          <a:spcPts val="930"/>
                        </a:spcBef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yrimidine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ibo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u</a:t>
                      </a:r>
                      <a:r>
                        <a:rPr sz="11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leotide  biosynthetic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241935" marR="105410" indent="-129539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tress</a:t>
                      </a:r>
                      <a:r>
                        <a:rPr sz="1100" b="1" spc="-8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ickel</a:t>
                      </a:r>
                      <a:r>
                        <a:rPr sz="11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73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683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92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3810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270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73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683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92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3810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marL="255270" marR="25400" indent="-222250">
                        <a:lnSpc>
                          <a:spcPct val="120000"/>
                        </a:lnSpc>
                        <a:spcBef>
                          <a:spcPts val="65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utoph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osome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assembl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831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0242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28575" marR="20320" indent="-635" algn="ctr">
                        <a:lnSpc>
                          <a:spcPct val="120000"/>
                        </a:lnSpc>
                        <a:spcBef>
                          <a:spcPts val="409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posttranscriptional  gene</a:t>
                      </a:r>
                      <a:r>
                        <a:rPr sz="1100" b="1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ilenc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206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8A8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05104" marR="127635" indent="-70485">
                        <a:lnSpc>
                          <a:spcPct val="120000"/>
                        </a:lnSpc>
                        <a:spcBef>
                          <a:spcPts val="66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utophag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6839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92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3810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31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780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206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8A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500">
                        <a:latin typeface="Times New Roman"/>
                        <a:cs typeface="Times New Roman"/>
                      </a:endParaRPr>
                    </a:p>
                    <a:p>
                      <a:pPr marL="23495" marR="16510" indent="-635" algn="ctr">
                        <a:lnSpc>
                          <a:spcPct val="111000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attachment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spindle  microtubules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kinetochore </a:t>
                      </a:r>
                      <a:r>
                        <a:rPr sz="600" b="1" spc="-10" dirty="0">
                          <a:latin typeface="Arial"/>
                          <a:cs typeface="Arial"/>
                        </a:rPr>
                        <a:t>involved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in  homologous</a:t>
                      </a:r>
                      <a:r>
                        <a:rPr sz="600" b="1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chromosome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segregation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39065" marR="43180" indent="-52705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llen−pistil  interac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400">
                        <a:latin typeface="Times New Roman"/>
                        <a:cs typeface="Times New Roman"/>
                      </a:endParaRPr>
                    </a:p>
                    <a:p>
                      <a:pPr marL="226060" marR="153670" indent="2794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rought  rec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ve</a:t>
                      </a:r>
                      <a:r>
                        <a:rPr sz="1100" b="1" spc="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9B8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60960" marR="2540" algn="ctr">
                        <a:lnSpc>
                          <a:spcPct val="120000"/>
                        </a:lnSpc>
                        <a:spcBef>
                          <a:spcPts val="78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intracellular  pH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3810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1778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ranspir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R="52705" algn="ctr">
                        <a:lnSpc>
                          <a:spcPct val="100000"/>
                        </a:lnSpc>
                        <a:spcBef>
                          <a:spcPts val="77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RNA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R="36195" algn="ctr">
                        <a:lnSpc>
                          <a:spcPct val="100000"/>
                        </a:lnSpc>
                        <a:spcBef>
                          <a:spcPts val="23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transcrip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31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58534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50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206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8A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89B8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906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3810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5AC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241935" marR="168275" indent="-66040">
                        <a:lnSpc>
                          <a:spcPct val="120000"/>
                        </a:lnSpc>
                        <a:spcBef>
                          <a:spcPts val="54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r>
                        <a:rPr sz="1100" b="1" spc="-9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 nematod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92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E78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19" name="object 19"/>
          <p:cNvSpPr txBox="1"/>
          <p:nvPr/>
        </p:nvSpPr>
        <p:spPr>
          <a:xfrm>
            <a:off x="12544806" y="5227066"/>
            <a:ext cx="1162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5" dirty="0">
                <a:latin typeface="Arial"/>
                <a:cs typeface="Arial"/>
              </a:rPr>
              <a:t>m</a:t>
            </a:r>
            <a:endParaRPr sz="800">
              <a:latin typeface="Arial"/>
              <a:cs typeface="Arial"/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12344400" y="8270484"/>
            <a:ext cx="2743200" cy="2912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B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482460" y="123317"/>
            <a:ext cx="166623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Biological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Processes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620306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0066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620306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652081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4790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652081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83856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C6DD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83856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715632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D6D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715632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47407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8E8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747407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791831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424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791831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810958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810958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 txBox="1"/>
          <p:nvPr/>
        </p:nvSpPr>
        <p:spPr>
          <a:xfrm>
            <a:off x="6260972" y="7763891"/>
            <a:ext cx="2108835" cy="3695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  <a:tabLst>
                <a:tab pos="317500" algn="l"/>
                <a:tab pos="635000" algn="l"/>
                <a:tab pos="953135" algn="l"/>
                <a:tab pos="1270635" algn="l"/>
                <a:tab pos="1588135" algn="l"/>
                <a:tab pos="1906270" algn="l"/>
              </a:tabLst>
            </a:pP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2	</a:t>
            </a: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4	</a:t>
            </a: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6	</a:t>
            </a: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8	</a:t>
            </a:r>
            <a:r>
              <a:rPr sz="1000" spc="-5" dirty="0">
                <a:latin typeface="Arial"/>
                <a:cs typeface="Arial"/>
              </a:rPr>
              <a:t>2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2.2</a:t>
            </a:r>
            <a:endParaRPr sz="10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65"/>
              </a:spcBef>
            </a:pPr>
            <a:r>
              <a:rPr sz="1200" spc="-5" dirty="0">
                <a:latin typeface="Arial"/>
                <a:cs typeface="Arial"/>
              </a:rPr>
              <a:t>Enrichmen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core</a:t>
            </a:r>
            <a:endParaRPr sz="1200">
              <a:latin typeface="Arial"/>
              <a:cs typeface="Arial"/>
            </a:endParaRPr>
          </a:p>
        </p:txBody>
      </p:sp>
      <p:graphicFrame>
        <p:nvGraphicFramePr>
          <p:cNvPr id="18" name="object 18"/>
          <p:cNvGraphicFramePr>
            <a:graphicFrameLocks noGrp="1"/>
          </p:cNvGraphicFramePr>
          <p:nvPr/>
        </p:nvGraphicFramePr>
        <p:xfrm>
          <a:off x="170434" y="400431"/>
          <a:ext cx="14361790" cy="707227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973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8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14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093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506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763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423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3883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795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6169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509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82804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2572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7310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90194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458470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42240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307975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243205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73659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</a:tblGrid>
              <a:tr h="1074102"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79375">
                        <a:lnSpc>
                          <a:spcPct val="100000"/>
                        </a:lnSpc>
                        <a:spcBef>
                          <a:spcPts val="894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hromatin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or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441325" marR="92710" indent="-34036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on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membrane  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31445" marR="123825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embryo  development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nding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eed  dormanc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142875" marR="135255" indent="-635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o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194310" marR="186690" indent="14478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ocal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757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224790" marR="27305" indent="-190500">
                        <a:lnSpc>
                          <a:spcPct val="115599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protein</a:t>
                      </a:r>
                      <a:r>
                        <a:rPr sz="10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targeting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1000" b="1" spc="-1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10" dirty="0">
                          <a:latin typeface="Arial"/>
                          <a:cs typeface="Arial"/>
                        </a:rPr>
                        <a:t>vacuole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62230" marR="48895" indent="-63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ectin  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138430" marR="122555" algn="ctr">
                        <a:lnSpc>
                          <a:spcPct val="120800"/>
                        </a:lnSpc>
                      </a:pPr>
                      <a:r>
                        <a:rPr sz="600" b="1" dirty="0">
                          <a:latin typeface="Arial"/>
                          <a:cs typeface="Arial"/>
                        </a:rPr>
                        <a:t>positive</a:t>
                      </a:r>
                      <a:r>
                        <a:rPr sz="6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600" b="1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transcription</a:t>
                      </a:r>
                      <a:endParaRPr sz="600">
                        <a:latin typeface="Arial"/>
                        <a:cs typeface="Arial"/>
                      </a:endParaRPr>
                    </a:p>
                    <a:p>
                      <a:pPr marL="78105" marR="62865" algn="ctr">
                        <a:lnSpc>
                          <a:spcPct val="120800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from RNA</a:t>
                      </a:r>
                      <a:r>
                        <a:rPr sz="6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olymerase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II</a:t>
                      </a:r>
                      <a:r>
                        <a:rPr sz="600" b="1" spc="-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romoter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569A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162560" marR="15494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efense  respon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11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viru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83185" marR="82550" indent="-635" algn="ctr">
                        <a:lnSpc>
                          <a:spcPct val="126299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catio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transmembrane  transpor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FF5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42545" marR="57785">
                        <a:lnSpc>
                          <a:spcPct val="100000"/>
                        </a:lnSpc>
                        <a:spcBef>
                          <a:spcPts val="560"/>
                        </a:spcBef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microsporogenesis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25400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hospholipid  transloc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9E9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21615" marR="16510" indent="-177165">
                        <a:lnSpc>
                          <a:spcPct val="116900"/>
                        </a:lnSpc>
                        <a:spcBef>
                          <a:spcPts val="765"/>
                        </a:spcBef>
                      </a:pPr>
                      <a:r>
                        <a:rPr sz="9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membrane  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528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29235" marR="171450" indent="-50800">
                        <a:lnSpc>
                          <a:spcPct val="120000"/>
                        </a:lnSpc>
                        <a:spcBef>
                          <a:spcPts val="66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r>
                        <a:rPr sz="11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alt</a:t>
                      </a:r>
                      <a:r>
                        <a:rPr sz="11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tr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2D81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0325">
                        <a:lnSpc>
                          <a:spcPct val="1000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oot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developmen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75AC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39370" marR="37465" algn="ctr">
                        <a:lnSpc>
                          <a:spcPct val="120400"/>
                        </a:lnSpc>
                        <a:spcBef>
                          <a:spcPts val="600"/>
                        </a:spcBef>
                      </a:pPr>
                      <a:r>
                        <a:rPr sz="700" b="1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700" b="1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lear−transcribed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mRNA catabolic  process, 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nonsense−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mediated  decay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6D6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02565" marR="175895" indent="-27305">
                        <a:lnSpc>
                          <a:spcPct val="120000"/>
                        </a:lnSpc>
                        <a:spcBef>
                          <a:spcPts val="7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ythm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60960" marR="53975" indent="-635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steroi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44450" marR="29209" algn="ctr">
                        <a:lnSpc>
                          <a:spcPct val="1241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transcription,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DNA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−templated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 marR="57785"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R="57785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550">
                        <a:latin typeface="Times New Roman"/>
                        <a:cs typeface="Times New Roman"/>
                      </a:endParaRPr>
                    </a:p>
                    <a:p>
                      <a:pPr marL="108585" marR="57785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NA</a:t>
                      </a:r>
                      <a:r>
                        <a:rPr sz="11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pair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270510" indent="-186055">
                        <a:lnSpc>
                          <a:spcPct val="125200"/>
                        </a:lnSpc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microtubule−based  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movement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 marL="43180" algn="ctr">
                        <a:lnSpc>
                          <a:spcPts val="1215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efense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74930" marR="2413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by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llo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deposition  in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11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wall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242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353695" marR="104139" indent="-24257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lignin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5B5B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24130" marR="16510" indent="-635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phosphop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tein  phosphatas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tiv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2D8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75AC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6D6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969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550">
                        <a:latin typeface="Times New Roman"/>
                        <a:cs typeface="Times New Roman"/>
                      </a:endParaRPr>
                    </a:p>
                    <a:p>
                      <a:pPr marL="378460">
                        <a:lnSpc>
                          <a:spcPct val="10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proteoly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5B5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2D8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75AC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6D6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9915"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13664">
                        <a:lnSpc>
                          <a:spcPct val="1000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unidimensional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900" b="1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growth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5B5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2D8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75AC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6D6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7D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941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5B5B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217804" marR="210820" algn="ctr">
                        <a:lnSpc>
                          <a:spcPct val="120000"/>
                        </a:lnSpc>
                        <a:spcBef>
                          <a:spcPts val="819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nitrogen  compound  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0413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46355">
                        <a:lnSpc>
                          <a:spcPct val="1000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mRNA</a:t>
                      </a:r>
                      <a:r>
                        <a:rPr sz="10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transport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6794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11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divis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82550" marR="42545" indent="-38735">
                        <a:lnSpc>
                          <a:spcPct val="116799"/>
                        </a:lnSpc>
                      </a:pPr>
                      <a:r>
                        <a:rPr sz="600" b="1" dirty="0">
                          <a:latin typeface="Arial"/>
                          <a:cs typeface="Arial"/>
                        </a:rPr>
                        <a:t>phosphati</a:t>
                      </a:r>
                      <a:r>
                        <a:rPr sz="600" b="1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ylinositol  metabolic</a:t>
                      </a:r>
                      <a:r>
                        <a:rPr sz="600" b="1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66040" marR="66675" indent="155575">
                        <a:lnSpc>
                          <a:spcPct val="12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vacuol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 marL="36830" marR="12065" indent="-635" algn="ctr">
                        <a:lnSpc>
                          <a:spcPct val="118300"/>
                        </a:lnSpc>
                        <a:spcBef>
                          <a:spcPts val="76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nucleic acid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phosphodiester  bond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hydrolysi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9715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R="57785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61594" marR="116205" algn="ctr">
                        <a:lnSpc>
                          <a:spcPct val="114999"/>
                        </a:lnSpc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positive</a:t>
                      </a:r>
                      <a:r>
                        <a:rPr sz="8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abscisic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acid−activated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signaling</a:t>
                      </a:r>
                      <a:r>
                        <a:rPr sz="8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pathway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550">
                        <a:latin typeface="Times New Roman"/>
                        <a:cs typeface="Times New Roman"/>
                      </a:endParaRPr>
                    </a:p>
                    <a:p>
                      <a:pPr marL="1905" marR="51435" algn="ctr">
                        <a:lnSpc>
                          <a:spcPct val="122600"/>
                        </a:lnSpc>
                      </a:pPr>
                      <a:r>
                        <a:rPr sz="600" b="1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600" b="1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leobase−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containing  compound metabolic  process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31115" marR="28575" indent="19685" algn="just">
                        <a:lnSpc>
                          <a:spcPct val="120000"/>
                        </a:lnSpc>
                        <a:spcBef>
                          <a:spcPts val="90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ulticellular  organismal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1430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491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400">
                        <a:latin typeface="Times New Roman"/>
                        <a:cs typeface="Times New Roman"/>
                      </a:endParaRPr>
                    </a:p>
                    <a:p>
                      <a:pPr marL="88265" marR="81280" indent="13589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bsenc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igh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1550">
                        <a:latin typeface="Times New Roman"/>
                        <a:cs typeface="Times New Roman"/>
                      </a:endParaRPr>
                    </a:p>
                    <a:p>
                      <a:pPr marL="287655" marR="11430" indent="-26924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RNA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413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715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430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146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marL="316865">
                        <a:lnSpc>
                          <a:spcPct val="10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on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413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715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430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052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04139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 marL="83185" marR="67310" algn="ctr">
                        <a:lnSpc>
                          <a:spcPts val="1580"/>
                        </a:lnSpc>
                        <a:spcBef>
                          <a:spcPts val="2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li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r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51435" indent="22479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flower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R="57785"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175895" marR="123189" indent="-70485">
                        <a:lnSpc>
                          <a:spcPct val="125499"/>
                        </a:lnSpc>
                        <a:spcBef>
                          <a:spcPts val="409"/>
                        </a:spcBef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pepti</a:t>
                      </a:r>
                      <a:r>
                        <a:rPr sz="700" b="1" spc="-15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yl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−L−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ysteine  S−palmitoylation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 marL="114935" marR="133350" algn="ctr">
                        <a:lnSpc>
                          <a:spcPct val="120000"/>
                        </a:lnSpc>
                        <a:spcBef>
                          <a:spcPts val="66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glucos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838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45415" marR="93345" indent="-39370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lateral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root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form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634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2065">
                        <a:lnSpc>
                          <a:spcPct val="100000"/>
                        </a:lnSpc>
                        <a:spcBef>
                          <a:spcPts val="68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tein</a:t>
                      </a:r>
                      <a:r>
                        <a:rPr sz="1100" b="1" spc="-5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3937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hosphorylation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60960">
                        <a:lnSpc>
                          <a:spcPct val="10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endocyto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43815" marR="41910" indent="-635" algn="ctr">
                        <a:lnSpc>
                          <a:spcPct val="1221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f  unidimensional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growth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38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1983"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85750" marR="277495" indent="166370">
                        <a:lnSpc>
                          <a:spcPct val="120000"/>
                        </a:lnSpc>
                        <a:spcBef>
                          <a:spcPts val="77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ntracellular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tein</a:t>
                      </a:r>
                      <a:r>
                        <a:rPr sz="11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38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493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95885" marR="8826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hosphate ion  transmembrane  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119380" marR="100330" indent="-1143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RNA</a:t>
                      </a:r>
                      <a:r>
                        <a:rPr sz="1100" b="1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xport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from</a:t>
                      </a:r>
                      <a:r>
                        <a:rPr sz="1100" b="1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nucleu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28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382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144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0A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 marL="97790" marR="82550" algn="ctr">
                        <a:lnSpc>
                          <a:spcPct val="120000"/>
                        </a:lnSpc>
                        <a:spcBef>
                          <a:spcPts val="77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NA  met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y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984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1206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52705" marR="55880" indent="227329">
                        <a:lnSpc>
                          <a:spcPct val="118400"/>
                        </a:lnSpc>
                      </a:pPr>
                      <a:r>
                        <a:rPr sz="8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tein  </a:t>
                      </a:r>
                      <a:r>
                        <a:rPr sz="8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hospho</a:t>
                      </a:r>
                      <a:r>
                        <a:rPr sz="8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8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yl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226060" marR="176530" indent="-177165">
                        <a:lnSpc>
                          <a:spcPts val="1270"/>
                        </a:lnSpc>
                        <a:spcBef>
                          <a:spcPts val="240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brassinoste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id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ediated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984250">
                        <a:lnSpc>
                          <a:spcPts val="34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226060" marR="57785">
                        <a:lnSpc>
                          <a:spcPts val="645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signaling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980440" marR="29845">
                        <a:lnSpc>
                          <a:spcPts val="635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249554" marR="57785">
                        <a:lnSpc>
                          <a:spcPts val="85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pathwa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30480" marB="0">
                    <a:lnL w="19050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24130" marR="49530" indent="81280">
                        <a:lnSpc>
                          <a:spcPct val="119100"/>
                        </a:lnSpc>
                        <a:spcBef>
                          <a:spcPts val="770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nucleoside  onophosphate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hospho</a:t>
                      </a:r>
                      <a:r>
                        <a:rPr sz="900" b="1" spc="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yl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9779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 marL="37465" marR="51435" algn="ctr">
                        <a:lnSpc>
                          <a:spcPct val="120000"/>
                        </a:lnSpc>
                        <a:spcBef>
                          <a:spcPts val="28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lant−typ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wall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odific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619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234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319405" marR="200660" indent="-111125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st−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mb</a:t>
                      </a:r>
                      <a:r>
                        <a:rPr sz="1100" b="1" spc="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spc="-30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nic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de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56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84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0480" marB="0">
                    <a:lnL w="19050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779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619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8461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40335" marR="132715" indent="38735">
                        <a:lnSpc>
                          <a:spcPct val="120000"/>
                        </a:lnSpc>
                        <a:spcBef>
                          <a:spcPts val="86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bscisic</a:t>
                      </a:r>
                      <a:r>
                        <a:rPr sz="1100" b="1" spc="-8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cid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rowSpan="5">
                  <a:txBody>
                    <a:bodyPr/>
                    <a:lstStyle/>
                    <a:p>
                      <a:pPr marL="173990" marR="166370" algn="ctr">
                        <a:lnSpc>
                          <a:spcPct val="120000"/>
                        </a:lnSpc>
                        <a:spcBef>
                          <a:spcPts val="65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si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1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cataly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tiv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825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 marL="119380" marR="32384" indent="-85725">
                        <a:lnSpc>
                          <a:spcPct val="123000"/>
                        </a:lnSpc>
                        <a:spcBef>
                          <a:spcPts val="515"/>
                        </a:spcBef>
                      </a:pPr>
                      <a:r>
                        <a:rPr sz="700" b="1" dirty="0">
                          <a:latin typeface="Arial"/>
                          <a:cs typeface="Arial"/>
                        </a:rPr>
                        <a:t>phosphati</a:t>
                      </a:r>
                      <a:r>
                        <a:rPr sz="700" b="1" spc="-15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ylinositol  phosphorylation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42545" marR="41275" indent="171450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single  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il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84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0480" marB="0">
                    <a:lnL w="19050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7790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619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25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984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066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 marL="88900" marR="81280" algn="ctr">
                        <a:lnSpc>
                          <a:spcPct val="120000"/>
                        </a:lnSpc>
                        <a:spcBef>
                          <a:spcPts val="88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light  intens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1176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1D1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550">
                        <a:latin typeface="Times New Roman"/>
                        <a:cs typeface="Times New Roman"/>
                      </a:endParaRPr>
                    </a:p>
                    <a:p>
                      <a:pPr marL="111125" marR="103505" indent="-635" algn="ctr">
                        <a:lnSpc>
                          <a:spcPct val="117600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signal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transduction  </a:t>
                      </a:r>
                      <a:r>
                        <a:rPr sz="600" b="1" spc="-10" dirty="0">
                          <a:latin typeface="Arial"/>
                          <a:cs typeface="Arial"/>
                        </a:rPr>
                        <a:t>by</a:t>
                      </a:r>
                      <a:r>
                        <a:rPr sz="600" b="1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rotein</a:t>
                      </a:r>
                      <a:endParaRPr sz="6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25"/>
                        </a:spcBef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phosphorylation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89535" marR="35560" indent="-46990">
                        <a:lnSpc>
                          <a:spcPct val="123700"/>
                        </a:lnSpc>
                        <a:spcBef>
                          <a:spcPts val="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amino</a:t>
                      </a:r>
                      <a:r>
                        <a:rPr sz="9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acid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450">
                        <a:latin typeface="Times New Roman"/>
                        <a:cs typeface="Times New Roman"/>
                      </a:endParaRPr>
                    </a:p>
                    <a:p>
                      <a:pPr marL="157480" marR="149860" algn="ctr">
                        <a:lnSpc>
                          <a:spcPct val="124400"/>
                        </a:lnSpc>
                      </a:pPr>
                      <a:r>
                        <a:rPr sz="6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600" b="1" spc="-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ion</a:t>
                      </a:r>
                      <a:endParaRPr sz="600">
                        <a:latin typeface="Arial"/>
                        <a:cs typeface="Arial"/>
                      </a:endParaRPr>
                    </a:p>
                    <a:p>
                      <a:pPr marL="55880" marR="48260" algn="ctr">
                        <a:lnSpc>
                          <a:spcPct val="124400"/>
                        </a:lnSpc>
                        <a:spcBef>
                          <a:spcPts val="5"/>
                        </a:spcBef>
                      </a:pPr>
                      <a:r>
                        <a:rPr sz="600" b="1" dirty="0">
                          <a:latin typeface="Arial"/>
                          <a:cs typeface="Arial"/>
                        </a:rPr>
                        <a:t>transmembrane  transport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3300"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205740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NA</a:t>
                      </a:r>
                      <a:r>
                        <a:rPr sz="11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methy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89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25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ADAD"/>
                    </a:solidFill>
                  </a:tcPr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67945" marR="52705" algn="ctr">
                        <a:lnSpc>
                          <a:spcPct val="125600"/>
                        </a:lnSpc>
                      </a:pPr>
                      <a:r>
                        <a:rPr sz="900" b="1" spc="-10" dirty="0">
                          <a:latin typeface="Arial"/>
                          <a:cs typeface="Arial"/>
                        </a:rPr>
                        <a:t>vesicle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ransport</a:t>
                      </a:r>
                      <a:r>
                        <a:rPr sz="9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along  actin</a:t>
                      </a:r>
                      <a:r>
                        <a:rPr sz="900" b="1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filamen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82550" marR="85725" algn="ctr">
                        <a:lnSpc>
                          <a:spcPct val="124700"/>
                        </a:lnSpc>
                      </a:pPr>
                      <a:r>
                        <a:rPr sz="800" b="1" spc="-25" dirty="0">
                          <a:latin typeface="Arial"/>
                          <a:cs typeface="Arial"/>
                        </a:rPr>
                        <a:t>ATP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hydrolysis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coupled</a:t>
                      </a:r>
                      <a:r>
                        <a:rPr sz="8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proto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transpor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176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367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8E8E"/>
                    </a:solidFill>
                  </a:tcPr>
                </a:tc>
                <a:tc rowSpan="8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41275" marR="33655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vesicle−mediate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86360" marR="78740" algn="ctr">
                        <a:lnSpc>
                          <a:spcPct val="125499"/>
                        </a:lnSpc>
                        <a:spcBef>
                          <a:spcPts val="87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lant−type primary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cell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wall</a:t>
                      </a:r>
                      <a:r>
                        <a:rPr sz="9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biogenesi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rowSpan="8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1000" b="1" dirty="0">
                          <a:latin typeface="Arial"/>
                          <a:cs typeface="Arial"/>
                        </a:rPr>
                        <a:t>leaf</a:t>
                      </a:r>
                      <a:r>
                        <a:rPr sz="1000" b="1" spc="-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10" dirty="0">
                          <a:latin typeface="Arial"/>
                          <a:cs typeface="Arial"/>
                        </a:rPr>
                        <a:t>development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0795" marR="3175" indent="-635" algn="ctr">
                        <a:lnSpc>
                          <a:spcPct val="120000"/>
                        </a:lnSpc>
                        <a:spcBef>
                          <a:spcPts val="6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deubiquitin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25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176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829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318135" marR="310515" indent="-63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spons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dmium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on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RNA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25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176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3299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56515" marR="49530" algn="ctr">
                        <a:lnSpc>
                          <a:spcPct val="120000"/>
                        </a:lnSpc>
                        <a:spcBef>
                          <a:spcPts val="780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activ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GTPase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tivity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01600" marR="93980" algn="ctr">
                        <a:lnSpc>
                          <a:spcPct val="120000"/>
                        </a:lnSpc>
                        <a:spcBef>
                          <a:spcPts val="7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07950" marR="100330" indent="223520">
                        <a:lnSpc>
                          <a:spcPct val="120000"/>
                        </a:lnSpc>
                        <a:spcBef>
                          <a:spcPts val="95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llen  d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5B9D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32410" marR="161290" indent="-70485">
                        <a:lnSpc>
                          <a:spcPct val="120000"/>
                        </a:lnSpc>
                        <a:spcBef>
                          <a:spcPts val="869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i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dian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rhythm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93BE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113030" marR="111760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xylan  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1C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1176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7FB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3BE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214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93B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ADAD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64135" marR="48895" algn="ctr">
                        <a:lnSpc>
                          <a:spcPct val="1245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ositive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GTPase</a:t>
                      </a:r>
                      <a:r>
                        <a:rPr sz="900" b="1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activit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1590" marR="24130" indent="57150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llen tube  d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velopmen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28575" marR="20320" indent="-635" algn="ctr">
                        <a:lnSpc>
                          <a:spcPct val="1195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acti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filament−based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movemen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E0E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23495" marR="15875" algn="ctr">
                        <a:lnSpc>
                          <a:spcPct val="119600"/>
                        </a:lnSpc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photosynthesis,  light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68580" marR="60960" indent="-635" algn="ctr">
                        <a:lnSpc>
                          <a:spcPct val="1196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harvesting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in  photosystem</a:t>
                      </a:r>
                      <a:r>
                        <a:rPr sz="800" b="1" spc="-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I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47625" marR="40005" algn="ctr">
                        <a:lnSpc>
                          <a:spcPct val="122500"/>
                        </a:lnSpc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f      transl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190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67525"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67945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11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hap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39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solidFill>
                      <a:srgbClr val="93B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solidFill>
                      <a:srgbClr val="FFADAD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3855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39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132715" marR="31750" indent="-93345">
                        <a:lnSpc>
                          <a:spcPct val="1167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protein</a:t>
                      </a:r>
                      <a:r>
                        <a:rPr sz="1000" b="1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N−linked  </a:t>
                      </a:r>
                      <a:r>
                        <a:rPr sz="1000" b="1" spc="-10" dirty="0">
                          <a:latin typeface="Arial"/>
                          <a:cs typeface="Arial"/>
                        </a:rPr>
                        <a:t>glycosylation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56515" marR="54610" indent="-635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chlorophyll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44780" marR="143510" algn="ctr">
                        <a:lnSpc>
                          <a:spcPct val="114399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protein  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ta</a:t>
                      </a:r>
                      <a:r>
                        <a:rPr sz="1000" b="1" spc="-1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000" b="1" spc="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eting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70"/>
                        </a:spcBef>
                      </a:pPr>
                      <a:r>
                        <a:rPr sz="10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10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membrane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8CA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435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39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59690" marR="45085" algn="ctr">
                        <a:lnSpc>
                          <a:spcPct val="1231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agnesium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ion  transmembrane  transport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2">
                  <a:txBody>
                    <a:bodyPr/>
                    <a:lstStyle/>
                    <a:p>
                      <a:pPr marR="12065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01600" marR="59055" indent="-4572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NA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duplex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unwind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2">
                  <a:txBody>
                    <a:bodyPr/>
                    <a:lstStyle/>
                    <a:p>
                      <a:pPr marL="12065" marR="4445" algn="ctr">
                        <a:lnSpc>
                          <a:spcPct val="120000"/>
                        </a:lnSpc>
                        <a:spcBef>
                          <a:spcPts val="51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nesium  ion   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5404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35560" marR="28575" algn="ctr">
                        <a:lnSpc>
                          <a:spcPct val="118300"/>
                        </a:lnSpc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sphingolipid  metabolic  proces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53022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939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B9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BA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A3C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9F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AEA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1D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1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5404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0E0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ts val="1185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76835" marR="69215" algn="ctr">
                        <a:lnSpc>
                          <a:spcPct val="114999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hosphodiester  bond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hydroly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</a:tbl>
          </a:graphicData>
        </a:graphic>
      </p:graphicFrame>
      <p:sp>
        <p:nvSpPr>
          <p:cNvPr id="20" name="Rettangolo 19"/>
          <p:cNvSpPr/>
          <p:nvPr/>
        </p:nvSpPr>
        <p:spPr>
          <a:xfrm>
            <a:off x="12420600" y="8305800"/>
            <a:ext cx="2743200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C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482460" y="123317"/>
            <a:ext cx="166623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Arial"/>
                <a:cs typeface="Arial"/>
              </a:rPr>
              <a:t>Biological</a:t>
            </a:r>
            <a:r>
              <a:rPr sz="1400" spc="-80" dirty="0">
                <a:latin typeface="Arial"/>
                <a:cs typeface="Arial"/>
              </a:rPr>
              <a:t> </a:t>
            </a:r>
            <a:r>
              <a:rPr sz="1400" dirty="0">
                <a:latin typeface="Arial"/>
                <a:cs typeface="Arial"/>
              </a:rPr>
              <a:t>Processes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636193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3887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6361938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4" y="97282"/>
                </a:lnTo>
                <a:lnTo>
                  <a:pt x="317754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667969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A8CA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6679692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99744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EAE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997445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731520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939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7315200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63295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424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7632954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95070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950707" y="7687564"/>
            <a:ext cx="318135" cy="97790"/>
          </a:xfrm>
          <a:custGeom>
            <a:avLst/>
            <a:gdLst/>
            <a:ahLst/>
            <a:cxnLst/>
            <a:rect l="l" t="t" r="r" b="b"/>
            <a:pathLst>
              <a:path w="318134" h="97790">
                <a:moveTo>
                  <a:pt x="0" y="97282"/>
                </a:moveTo>
                <a:lnTo>
                  <a:pt x="317753" y="97282"/>
                </a:lnTo>
                <a:lnTo>
                  <a:pt x="317753" y="0"/>
                </a:lnTo>
                <a:lnTo>
                  <a:pt x="0" y="0"/>
                </a:lnTo>
                <a:lnTo>
                  <a:pt x="0" y="97282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6419850" y="7763891"/>
            <a:ext cx="1790700" cy="3695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  <a:tabLst>
                <a:tab pos="317500" algn="l"/>
                <a:tab pos="635000" algn="l"/>
                <a:tab pos="953135" algn="l"/>
                <a:tab pos="1270635" algn="l"/>
                <a:tab pos="1588135" algn="l"/>
              </a:tabLst>
            </a:pPr>
            <a:r>
              <a:rPr sz="1000" spc="-5" dirty="0">
                <a:latin typeface="Arial"/>
                <a:cs typeface="Arial"/>
              </a:rPr>
              <a:t>1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2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2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3.</a:t>
            </a:r>
            <a:r>
              <a:rPr sz="1000" dirty="0">
                <a:latin typeface="Arial"/>
                <a:cs typeface="Arial"/>
              </a:rPr>
              <a:t>0	</a:t>
            </a:r>
            <a:r>
              <a:rPr sz="1000" spc="-5" dirty="0">
                <a:latin typeface="Arial"/>
                <a:cs typeface="Arial"/>
              </a:rPr>
              <a:t>3.</a:t>
            </a:r>
            <a:r>
              <a:rPr sz="1000" dirty="0">
                <a:latin typeface="Arial"/>
                <a:cs typeface="Arial"/>
              </a:rPr>
              <a:t>5	</a:t>
            </a:r>
            <a:r>
              <a:rPr sz="1000" spc="-5" dirty="0">
                <a:latin typeface="Arial"/>
                <a:cs typeface="Arial"/>
              </a:rPr>
              <a:t>4.0</a:t>
            </a:r>
            <a:endParaRPr sz="10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65"/>
              </a:spcBef>
            </a:pPr>
            <a:r>
              <a:rPr sz="1200" spc="-5" dirty="0">
                <a:latin typeface="Arial"/>
                <a:cs typeface="Arial"/>
              </a:rPr>
              <a:t>Enrichmen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core</a:t>
            </a:r>
            <a:endParaRPr sz="1200">
              <a:latin typeface="Arial"/>
              <a:cs typeface="Arial"/>
            </a:endParaRPr>
          </a:p>
        </p:txBody>
      </p:sp>
      <p:graphicFrame>
        <p:nvGraphicFramePr>
          <p:cNvPr id="16" name="object 16"/>
          <p:cNvGraphicFramePr>
            <a:graphicFrameLocks noGrp="1"/>
          </p:cNvGraphicFramePr>
          <p:nvPr/>
        </p:nvGraphicFramePr>
        <p:xfrm>
          <a:off x="170434" y="400494"/>
          <a:ext cx="14300823" cy="706589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580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815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585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348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2615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5504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7439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604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8452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9969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6192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54927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8762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8191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22884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409575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05409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46684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280034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32194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28904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153034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349250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61925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140969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641984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</a:tblGrid>
              <a:tr h="988568"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294005" marR="287020" indent="23622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lectron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 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upled proton</a:t>
                      </a:r>
                      <a:r>
                        <a:rPr sz="1100" b="1" spc="-6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174625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Group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I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intron</a:t>
                      </a:r>
                      <a:r>
                        <a:rPr sz="11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plic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600">
                        <a:latin typeface="Times New Roman"/>
                        <a:cs typeface="Times New Roman"/>
                      </a:endParaRPr>
                    </a:p>
                    <a:p>
                      <a:pPr marL="118745">
                        <a:lnSpc>
                          <a:spcPct val="10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heme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171450">
                        <a:lnSpc>
                          <a:spcPct val="10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NA</a:t>
                      </a:r>
                      <a:r>
                        <a:rPr sz="11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plic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86690" marR="179070" algn="ctr">
                        <a:lnSpc>
                          <a:spcPct val="120000"/>
                        </a:lnSpc>
                        <a:spcBef>
                          <a:spcPts val="64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2794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ito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hondrial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33655" marR="3175" algn="ctr">
                        <a:lnSpc>
                          <a:spcPct val="100000"/>
                        </a:lnSpc>
                        <a:spcBef>
                          <a:spcPts val="2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odific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8EBB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111125" marR="69215" algn="ctr">
                        <a:lnSpc>
                          <a:spcPct val="120000"/>
                        </a:lnSpc>
                        <a:spcBef>
                          <a:spcPts val="54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  response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sucros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timulu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9215" marB="0"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CB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6985" indent="123189">
                        <a:lnSpc>
                          <a:spcPct val="120000"/>
                        </a:lnSpc>
                        <a:spcBef>
                          <a:spcPts val="8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vegetativ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hase</a:t>
                      </a:r>
                      <a:r>
                        <a:rPr sz="11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hang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CB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45085" marR="37465" indent="112395">
                        <a:lnSpc>
                          <a:spcPct val="117500"/>
                        </a:lnSpc>
                        <a:spcBef>
                          <a:spcPts val="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floral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organ  morpho</a:t>
                      </a:r>
                      <a:r>
                        <a:rPr sz="900" b="1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enesi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10160" marR="254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ito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hondrial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39370">
                        <a:lnSpc>
                          <a:spcPct val="1000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hotoperiodism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0325" marR="53340" algn="ctr">
                        <a:lnSpc>
                          <a:spcPct val="124100"/>
                        </a:lnSpc>
                        <a:spcBef>
                          <a:spcPts val="680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NA</a:t>
                      </a:r>
                      <a:r>
                        <a:rPr sz="9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569A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938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rowSpan="5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57785" marR="59690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lant−typ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ell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wall  o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29845" marR="68580" indent="147955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targeting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hloroplas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50800" algn="ctr">
                        <a:lnSpc>
                          <a:spcPct val="100000"/>
                        </a:lnSpc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RNA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marL="107950" marR="159385" algn="ctr">
                        <a:lnSpc>
                          <a:spcPct val="115799"/>
                        </a:lnSpc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plicing,  via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marR="32384" algn="ctr">
                        <a:lnSpc>
                          <a:spcPct val="100000"/>
                        </a:lnSpc>
                        <a:spcBef>
                          <a:spcPts val="185"/>
                        </a:spcBef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pliceosome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50">
                        <a:latin typeface="Times New Roman"/>
                        <a:cs typeface="Times New Roman"/>
                      </a:endParaRPr>
                    </a:p>
                    <a:p>
                      <a:pPr marL="53975" marR="62230" indent="214629">
                        <a:lnSpc>
                          <a:spcPct val="126800"/>
                        </a:lnSpc>
                        <a:spcBef>
                          <a:spcPts val="5"/>
                        </a:spcBef>
                      </a:pPr>
                      <a:r>
                        <a:rPr sz="6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tein  </a:t>
                      </a:r>
                      <a:r>
                        <a:rPr sz="6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ephospho</a:t>
                      </a:r>
                      <a:r>
                        <a:rPr sz="6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sz="6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ylation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12065">
                        <a:lnSpc>
                          <a:spcPct val="1000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demethyl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25400" marR="73025" indent="-635" algn="ctr">
                        <a:lnSpc>
                          <a:spcPct val="116100"/>
                        </a:lnSpc>
                      </a:pPr>
                      <a:r>
                        <a:rPr sz="1000" b="1" dirty="0">
                          <a:latin typeface="Arial"/>
                          <a:cs typeface="Arial"/>
                        </a:rPr>
                        <a:t>galactolipid  biosynthetic 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 marL="5080" marR="71755" algn="ctr">
                        <a:lnSpc>
                          <a:spcPct val="120000"/>
                        </a:lnSpc>
                        <a:spcBef>
                          <a:spcPts val="30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gibberellin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diated  signaling  pathwa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87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77470" marR="91440" algn="ctr">
                        <a:lnSpc>
                          <a:spcPct val="120000"/>
                        </a:lnSpc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glycin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783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905">
                        <a:lnSpc>
                          <a:spcPct val="100000"/>
                        </a:lnSpc>
                        <a:spcBef>
                          <a:spcPts val="74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RNA</a:t>
                      </a:r>
                      <a:r>
                        <a:rPr sz="1100" b="1" spc="-7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r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rowSpan="5">
                  <a:txBody>
                    <a:bodyPr/>
                    <a:lstStyle/>
                    <a:p>
                      <a:pPr marL="54610" marR="46990" indent="-635" algn="ctr">
                        <a:lnSpc>
                          <a:spcPct val="120000"/>
                        </a:lnSpc>
                        <a:spcBef>
                          <a:spcPts val="95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otyledon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vascular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issue</a:t>
                      </a:r>
                      <a:r>
                        <a:rPr sz="1100" b="1" spc="-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attern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form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06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7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301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B2B2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112395">
                        <a:lnSpc>
                          <a:spcPct val="100000"/>
                        </a:lnSpc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hotosynthe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06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7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557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127635">
                        <a:lnSpc>
                          <a:spcPct val="1000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hotosynthesis, light</a:t>
                      </a:r>
                      <a:r>
                        <a:rPr sz="9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ac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06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7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3985">
                <a:tc row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542925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odific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06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C9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1472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4F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87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974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0F6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06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2FF"/>
                    </a:solidFill>
                  </a:tcPr>
                </a:tc>
                <a:tc row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marL="243204" marR="163830" indent="-81915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</a:t>
                      </a:r>
                      <a:r>
                        <a:rPr sz="11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ld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066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GMP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25400" marR="17780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marL="63500" marR="43815" indent="635" algn="ctr">
                        <a:lnSpc>
                          <a:spcPct val="120000"/>
                        </a:lnSpc>
                        <a:spcBef>
                          <a:spcPts val="37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nega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kinase  activ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469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23495" algn="ctr">
                        <a:lnSpc>
                          <a:spcPct val="112599"/>
                        </a:lnSpc>
                        <a:spcBef>
                          <a:spcPts val="540"/>
                        </a:spcBef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photosynthesis,  light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54610" marR="31115" indent="-635" algn="ctr">
                        <a:lnSpc>
                          <a:spcPct val="1127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harvesting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in  photosystem</a:t>
                      </a:r>
                      <a:r>
                        <a:rPr sz="800" b="1" spc="-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II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 marL="58419" marR="45085" algn="ctr">
                        <a:lnSpc>
                          <a:spcPct val="121800"/>
                        </a:lnSpc>
                        <a:spcBef>
                          <a:spcPts val="27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ositive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9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carotenoid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349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450">
                        <a:latin typeface="Times New Roman"/>
                        <a:cs typeface="Times New Roman"/>
                      </a:endParaRPr>
                    </a:p>
                    <a:p>
                      <a:pPr marL="28575" marR="67945" algn="ctr">
                        <a:lnSpc>
                          <a:spcPct val="116700"/>
                        </a:lnSpc>
                      </a:pPr>
                      <a:r>
                        <a:rPr sz="600" b="1" dirty="0">
                          <a:latin typeface="Arial"/>
                          <a:cs typeface="Arial"/>
                        </a:rPr>
                        <a:t>positive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reactive </a:t>
                      </a:r>
                      <a:r>
                        <a:rPr sz="600" b="1" spc="-10" dirty="0">
                          <a:latin typeface="Arial"/>
                          <a:cs typeface="Arial"/>
                        </a:rPr>
                        <a:t>oxygen 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species</a:t>
                      </a:r>
                      <a:r>
                        <a:rPr sz="6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6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600">
                        <a:latin typeface="Arial"/>
                        <a:cs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7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i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 marL="635" marR="23495" indent="-39370" algn="ctr">
                        <a:lnSpc>
                          <a:spcPct val="120000"/>
                        </a:lnSpc>
                        <a:spcBef>
                          <a:spcPts val="37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ositiv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NA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nter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renc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469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29845" marR="42545" indent="-635" algn="ctr">
                        <a:lnSpc>
                          <a:spcPct val="1232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regulation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f  dou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le−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strand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break</a:t>
                      </a:r>
                      <a:r>
                        <a:rPr sz="8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repair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607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339725" marR="34290" indent="-297815">
                        <a:lnSpc>
                          <a:spcPct val="120000"/>
                        </a:lnSpc>
                        <a:spcBef>
                          <a:spcPts val="795"/>
                        </a:spcBef>
                      </a:pPr>
                      <a:r>
                        <a:rPr sz="1100" b="1" spc="-35" dirty="0">
                          <a:latin typeface="Arial"/>
                          <a:cs typeface="Arial"/>
                        </a:rPr>
                        <a:t>ATP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05104" marR="44450" indent="-152400">
                        <a:lnSpc>
                          <a:spcPct val="119900"/>
                        </a:lnSpc>
                        <a:spcBef>
                          <a:spcPts val="5"/>
                        </a:spcBef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posttranscriptional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f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112395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gene</a:t>
                      </a:r>
                      <a:r>
                        <a:rPr sz="800" b="1" spc="-1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express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69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49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69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092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203835" marR="65405" indent="-131445">
                        <a:lnSpc>
                          <a:spcPct val="1222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sponse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active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oxygen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specie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006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44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69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492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469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532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DA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14935" marR="13335" indent="-104139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ito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hondrial  trans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53340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intron</a:t>
                      </a:r>
                      <a:r>
                        <a:rPr sz="9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homing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4" gridSpan="3">
                  <a:txBody>
                    <a:bodyPr/>
                    <a:lstStyle/>
                    <a:p>
                      <a:pPr marL="106680" marR="99695" algn="ctr">
                        <a:lnSpc>
                          <a:spcPts val="1580"/>
                        </a:lnSpc>
                        <a:spcBef>
                          <a:spcPts val="5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gene  silencing  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by</a:t>
                      </a:r>
                      <a:r>
                        <a:rPr sz="11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U5</a:t>
                      </a:r>
                      <a:r>
                        <a:rPr sz="1100" b="1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n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27940" marR="20320" indent="-63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3−en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R="13970"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DNA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41910" marR="55880" indent="-635" algn="ctr">
                        <a:lnSpc>
                          <a:spcPct val="119100"/>
                        </a:lnSpc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mediated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trans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rm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9B8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152400" marR="162560" algn="ctr">
                        <a:lnSpc>
                          <a:spcPct val="119900"/>
                        </a:lnSpc>
                        <a:spcBef>
                          <a:spcPts val="550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abaxial  cell</a:t>
                      </a:r>
                      <a:r>
                        <a:rPr sz="9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fate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R="9525" algn="ctr">
                        <a:lnSpc>
                          <a:spcPct val="100000"/>
                        </a:lnSpc>
                        <a:spcBef>
                          <a:spcPts val="21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specific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 marL="37465" marR="17780" algn="ctr">
                        <a:lnSpc>
                          <a:spcPct val="121000"/>
                        </a:lnSpc>
                        <a:spcBef>
                          <a:spcPts val="635"/>
                        </a:spcBef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photosynthetic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electron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transport in  photosystem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20320" marR="3175" algn="ctr">
                        <a:lnSpc>
                          <a:spcPct val="100000"/>
                        </a:lnSpc>
                        <a:spcBef>
                          <a:spcPts val="200"/>
                        </a:spcBef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II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806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56515" marR="41910" indent="-635" algn="ctr">
                        <a:lnSpc>
                          <a:spcPct val="120700"/>
                        </a:lnSpc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raffinose family  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oligosac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700" b="1" dirty="0">
                          <a:latin typeface="Arial"/>
                          <a:cs typeface="Arial"/>
                        </a:rPr>
                        <a:t>haride  biosynthetic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331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408940">
                        <a:lnSpc>
                          <a:spcPct val="100000"/>
                        </a:lnSpc>
                        <a:spcBef>
                          <a:spcPts val="80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DNA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integr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9B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06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8493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CE0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1550">
                        <a:latin typeface="Times New Roman"/>
                        <a:cs typeface="Times New Roman"/>
                      </a:endParaRPr>
                    </a:p>
                    <a:p>
                      <a:pPr marL="17780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atabolic</a:t>
                      </a:r>
                      <a:r>
                        <a:rPr sz="11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50800" marR="4381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innamic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ci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9B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06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87757">
                <a:tc rowSpan="10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55435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NA</a:t>
                      </a:r>
                      <a:r>
                        <a:rPr sz="11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tabil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9B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06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rowSpan="4">
                  <a:txBody>
                    <a:bodyPr/>
                    <a:lstStyle/>
                    <a:p>
                      <a:pPr marR="3175"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Arial"/>
                          <a:cs typeface="Arial"/>
                        </a:rPr>
                        <a:t>regulation</a:t>
                      </a:r>
                      <a:endParaRPr sz="1000">
                        <a:latin typeface="Arial"/>
                        <a:cs typeface="Arial"/>
                      </a:endParaRPr>
                    </a:p>
                    <a:p>
                      <a:pPr marL="34290" marR="36195" algn="ctr">
                        <a:lnSpc>
                          <a:spcPts val="1430"/>
                        </a:lnSpc>
                        <a:spcBef>
                          <a:spcPts val="85"/>
                        </a:spcBef>
                      </a:pPr>
                      <a:r>
                        <a:rPr sz="1000" b="1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bscisic  acid</a:t>
                      </a:r>
                      <a:r>
                        <a:rPr sz="1000" b="1" dirty="0">
                          <a:latin typeface="Arial"/>
                          <a:cs typeface="Arial"/>
                        </a:rPr>
                        <a:t>−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cti</a:t>
                      </a:r>
                      <a:r>
                        <a:rPr sz="1000" b="1" spc="-25" dirty="0">
                          <a:latin typeface="Arial"/>
                          <a:cs typeface="Arial"/>
                        </a:rPr>
                        <a:t>v</a:t>
                      </a:r>
                      <a:r>
                        <a:rPr sz="1000" b="1" spc="-5" dirty="0">
                          <a:latin typeface="Arial"/>
                          <a:cs typeface="Arial"/>
                        </a:rPr>
                        <a:t>ated  signaling  pathway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25400" marR="17780" indent="-635" algn="ctr">
                        <a:lnSpc>
                          <a:spcPct val="120000"/>
                        </a:lnSpc>
                        <a:spcBef>
                          <a:spcPts val="69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L−prolin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biosynthetic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8763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4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30480" marR="14604" indent="-9525">
                        <a:lnSpc>
                          <a:spcPct val="120000"/>
                        </a:lnSpc>
                        <a:spcBef>
                          <a:spcPts val="6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nucleus</a:t>
                      </a:r>
                      <a:r>
                        <a:rPr sz="1100" b="1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size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89B8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064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FFF4F4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9604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10160" marR="3175" indent="224790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cytochrome  complex</a:t>
                      </a:r>
                      <a:r>
                        <a:rPr sz="1100" b="1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assembl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D6E6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848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763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4">
                  <a:txBody>
                    <a:bodyPr/>
                    <a:lstStyle/>
                    <a:p>
                      <a:pPr marL="44450" marR="37465" algn="ctr">
                        <a:lnSpc>
                          <a:spcPct val="120000"/>
                        </a:lnSpc>
                        <a:spcBef>
                          <a:spcPts val="5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  response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unfolded  protei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40005" marR="10795" indent="136525">
                        <a:lnSpc>
                          <a:spcPct val="120900"/>
                        </a:lnSpc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histone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modificatio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6675" marR="3175" algn="ctr">
                        <a:lnSpc>
                          <a:spcPct val="123100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mito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hondrial 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mRNA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marL="65405" marR="3175" algn="ctr">
                        <a:lnSpc>
                          <a:spcPct val="100000"/>
                        </a:lnSpc>
                        <a:spcBef>
                          <a:spcPts val="220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processing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93980" marR="30480" indent="-635" algn="ctr">
                        <a:lnSpc>
                          <a:spcPct val="118500"/>
                        </a:lnSpc>
                        <a:spcBef>
                          <a:spcPts val="215"/>
                        </a:spcBef>
                      </a:pPr>
                      <a:r>
                        <a:rPr sz="300" b="1" spc="-5" dirty="0">
                          <a:latin typeface="Arial"/>
                          <a:cs typeface="Arial"/>
                        </a:rPr>
                        <a:t>protein targeting </a:t>
                      </a:r>
                      <a:r>
                        <a:rPr sz="300" b="1" dirty="0">
                          <a:latin typeface="Arial"/>
                          <a:cs typeface="Arial"/>
                        </a:rPr>
                        <a:t>to </a:t>
                      </a:r>
                      <a:r>
                        <a:rPr sz="300" b="1" spc="-5" dirty="0">
                          <a:latin typeface="Arial"/>
                          <a:cs typeface="Arial"/>
                        </a:rPr>
                        <a:t>vacuole  involved </a:t>
                      </a:r>
                      <a:r>
                        <a:rPr sz="300" b="1" dirty="0">
                          <a:latin typeface="Arial"/>
                          <a:cs typeface="Arial"/>
                        </a:rPr>
                        <a:t>in ubiquitin−dependent  </a:t>
                      </a:r>
                      <a:r>
                        <a:rPr sz="300" b="1" spc="-5" dirty="0">
                          <a:latin typeface="Arial"/>
                          <a:cs typeface="Arial"/>
                        </a:rPr>
                        <a:t>protein catabolic process via </a:t>
                      </a:r>
                      <a:r>
                        <a:rPr sz="300" b="1" dirty="0">
                          <a:latin typeface="Arial"/>
                          <a:cs typeface="Arial"/>
                        </a:rPr>
                        <a:t>the  </a:t>
                      </a:r>
                      <a:r>
                        <a:rPr sz="300" b="1" spc="-5" dirty="0">
                          <a:latin typeface="Arial"/>
                          <a:cs typeface="Arial"/>
                        </a:rPr>
                        <a:t>multivesicular body </a:t>
                      </a:r>
                      <a:r>
                        <a:rPr sz="300" b="1" dirty="0">
                          <a:latin typeface="Arial"/>
                          <a:cs typeface="Arial"/>
                        </a:rPr>
                        <a:t>sorting</a:t>
                      </a:r>
                      <a:r>
                        <a:rPr sz="300" b="1" spc="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300" b="1" spc="-5" dirty="0">
                          <a:latin typeface="Arial"/>
                          <a:cs typeface="Arial"/>
                        </a:rPr>
                        <a:t>pathway</a:t>
                      </a:r>
                      <a:endParaRPr sz="3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3810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88900" marR="60325" indent="25400">
                        <a:lnSpc>
                          <a:spcPct val="126200"/>
                        </a:lnSpc>
                        <a:spcBef>
                          <a:spcPts val="66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root system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800" b="1" spc="-15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velopment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3810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641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CCC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85725" marR="78105" indent="384810">
                        <a:lnSpc>
                          <a:spcPct val="120000"/>
                        </a:lnSpc>
                        <a:spcBef>
                          <a:spcPts val="74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fruit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orpho</a:t>
                      </a:r>
                      <a:r>
                        <a:rPr sz="1100" b="1" spc="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ne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283845" marR="194945" indent="-81915">
                        <a:lnSpc>
                          <a:spcPct val="120000"/>
                        </a:lnSpc>
                        <a:spcBef>
                          <a:spcPts val="805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</a:t>
                      </a:r>
                      <a:r>
                        <a:rPr sz="11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ea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763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3810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3810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0553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rowSpan="9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393065" marR="170815" indent="-215265">
                        <a:lnSpc>
                          <a:spcPct val="120000"/>
                        </a:lnSpc>
                        <a:spcBef>
                          <a:spcPts val="975"/>
                        </a:spcBef>
                      </a:pPr>
                      <a:r>
                        <a:rPr sz="1100" b="1" spc="-35" dirty="0">
                          <a:latin typeface="Arial"/>
                          <a:cs typeface="Arial"/>
                        </a:rPr>
                        <a:t>ATP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ynthesis coupled  proton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8763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3810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3810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6997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rowSpan="5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55880" marR="57785" indent="-635" algn="ctr">
                        <a:lnSpc>
                          <a:spcPct val="1225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respiratory  </a:t>
                      </a:r>
                      <a:r>
                        <a:rPr sz="900" b="1" spc="-10" dirty="0">
                          <a:latin typeface="Arial"/>
                          <a:cs typeface="Arial"/>
                        </a:rPr>
                        <a:t>electron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transport</a:t>
                      </a:r>
                      <a:r>
                        <a:rPr sz="9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chain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4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6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odific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 gridSpan="3">
                  <a:txBody>
                    <a:bodyPr/>
                    <a:lstStyle/>
                    <a:p>
                      <a:pPr marL="12065" marR="4445" algn="ctr">
                        <a:lnSpc>
                          <a:spcPct val="120000"/>
                        </a:lnSpc>
                        <a:spcBef>
                          <a:spcPts val="17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RNA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wobbl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adenosine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o  inosine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dit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215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9EC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3810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3810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064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250">
                        <a:latin typeface="Times New Roman"/>
                        <a:cs typeface="Times New Roman"/>
                      </a:endParaRPr>
                    </a:p>
                    <a:p>
                      <a:pPr marL="142875" marR="135255" indent="61594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  re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ld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4C93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3810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3810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998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E5E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4C9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800" b="1" dirty="0">
                          <a:latin typeface="Arial"/>
                          <a:cs typeface="Arial"/>
                        </a:rPr>
                        <a:t>tRNA</a:t>
                      </a:r>
                      <a:endParaRPr sz="8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5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thio−modification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marL="13970" marR="6350" algn="ctr">
                        <a:lnSpc>
                          <a:spcPct val="114900"/>
                        </a:lnSpc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RNA cis  splicing, via  spliceosome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R="3175"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73660" indent="-12065">
                        <a:lnSpc>
                          <a:spcPct val="124900"/>
                        </a:lnSpc>
                        <a:spcBef>
                          <a:spcPts val="390"/>
                        </a:spcBef>
                      </a:pPr>
                      <a:r>
                        <a:rPr sz="6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NA−dependent  DNA</a:t>
                      </a:r>
                      <a:r>
                        <a:rPr sz="6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6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plication</a:t>
                      </a:r>
                      <a:endParaRPr sz="6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3384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91440" marR="17780" indent="46355">
                        <a:lnSpc>
                          <a:spcPct val="116300"/>
                        </a:lnSpc>
                        <a:spcBef>
                          <a:spcPts val="790"/>
                        </a:spcBef>
                      </a:pP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ibosome  </a:t>
                      </a:r>
                      <a:r>
                        <a:rPr sz="10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io</a:t>
                      </a:r>
                      <a:r>
                        <a:rPr sz="1000" b="1" spc="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g</a:t>
                      </a:r>
                      <a:r>
                        <a:rPr sz="10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nesis</a:t>
                      </a:r>
                      <a:endParaRPr sz="10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237BFF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006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42240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rotein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fold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4C9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338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237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948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107314" marR="99695" algn="ctr">
                        <a:lnSpc>
                          <a:spcPct val="12000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cellular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rotein  modification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98425" marR="90805" indent="152400">
                        <a:lnSpc>
                          <a:spcPct val="120000"/>
                        </a:lnSpc>
                        <a:spcBef>
                          <a:spcPts val="750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nucleus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2D1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2159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4C9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338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237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7293">
                <a:tc rowSpan="9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865"/>
                        </a:spcBef>
                      </a:pP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6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marL="24130" marR="26034" algn="ctr">
                        <a:lnSpc>
                          <a:spcPct val="116199"/>
                        </a:lnSpc>
                        <a:spcBef>
                          <a:spcPts val="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L−phe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ylalanine  catabolic  process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53340" marR="45720" algn="ctr">
                        <a:lnSpc>
                          <a:spcPct val="123100"/>
                        </a:lnSpc>
                      </a:pPr>
                      <a:r>
                        <a:rPr sz="900" b="1" spc="-2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ultivesicular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body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sorting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pathway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6" gridSpan="3">
                  <a:txBody>
                    <a:bodyPr/>
                    <a:lstStyle/>
                    <a:p>
                      <a:pPr marL="12065" marR="4445" algn="ctr">
                        <a:lnSpc>
                          <a:spcPct val="120000"/>
                        </a:lnSpc>
                        <a:spcBef>
                          <a:spcPts val="12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tRNA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wobble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 position  uridine  thiol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3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114300" marR="106680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me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66A3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3384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solidFill>
                      <a:srgbClr val="237B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gridSpan="4">
                  <a:txBody>
                    <a:bodyPr/>
                    <a:lstStyle/>
                    <a:p>
                      <a:pPr marL="34290" marR="26670" algn="ctr">
                        <a:lnSpc>
                          <a:spcPct val="121900"/>
                        </a:lnSpc>
                        <a:spcBef>
                          <a:spcPts val="495"/>
                        </a:spcBef>
                      </a:pPr>
                      <a:r>
                        <a:rPr sz="800" b="1" spc="-5" dirty="0">
                          <a:latin typeface="Arial"/>
                          <a:cs typeface="Arial"/>
                        </a:rPr>
                        <a:t>chaperone  mediated</a:t>
                      </a:r>
                      <a:r>
                        <a:rPr sz="8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protein  folding</a:t>
                      </a:r>
                      <a:r>
                        <a:rPr sz="800" b="1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requiring  cofactor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66A3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384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237B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649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9525" marR="1905" indent="102870">
                        <a:lnSpc>
                          <a:spcPct val="120000"/>
                        </a:lnSpc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ell </a:t>
                      </a:r>
                      <a:r>
                        <a:rPr sz="11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dox 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omeostasi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5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34925" marR="27305" algn="ctr">
                        <a:lnSpc>
                          <a:spcPct val="118500"/>
                        </a:lnSpc>
                      </a:pPr>
                      <a:r>
                        <a:rPr sz="8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yto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8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ome  b6f   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complex  assembly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27305" marR="20320" algn="ctr">
                        <a:lnSpc>
                          <a:spcPct val="123900"/>
                        </a:lnSpc>
                      </a:pPr>
                      <a:r>
                        <a:rPr sz="700" b="1" spc="-5" dirty="0">
                          <a:latin typeface="Arial"/>
                          <a:cs typeface="Arial"/>
                        </a:rPr>
                        <a:t>protein  maturation</a:t>
                      </a:r>
                      <a:r>
                        <a:rPr sz="7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700" b="1" spc="-10" dirty="0">
                          <a:latin typeface="Arial"/>
                          <a:cs typeface="Arial"/>
                        </a:rPr>
                        <a:t>by  </a:t>
                      </a:r>
                      <a:r>
                        <a:rPr sz="700" b="1" spc="-5" dirty="0">
                          <a:latin typeface="Arial"/>
                          <a:cs typeface="Arial"/>
                        </a:rPr>
                        <a:t>iron−sulfur  cluster  transfer</a:t>
                      </a:r>
                      <a:endParaRPr sz="7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6085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342900" marR="170815" indent="-165100">
                        <a:lnSpc>
                          <a:spcPct val="120000"/>
                        </a:lnSpc>
                        <a:spcBef>
                          <a:spcPts val="860"/>
                        </a:spcBef>
                      </a:pPr>
                      <a:r>
                        <a:rPr sz="1100" b="1" spc="-35" dirty="0">
                          <a:latin typeface="Arial"/>
                          <a:cs typeface="Arial"/>
                        </a:rPr>
                        <a:t>ATP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ynthesis coupled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electron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3D8A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8864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270">
                        <a:lnSpc>
                          <a:spcPct val="100000"/>
                        </a:lnSpc>
                        <a:spcBef>
                          <a:spcPts val="88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erobic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spir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1E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16649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1E3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97155" marR="89535" algn="ctr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hotosynthetic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electron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ransport</a:t>
                      </a:r>
                      <a:r>
                        <a:rPr sz="1100" b="1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hai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row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  <a:p>
                      <a:pPr marL="103505" marR="82550" indent="-13970">
                        <a:lnSpc>
                          <a:spcPct val="120000"/>
                        </a:lnSpc>
                        <a:spcBef>
                          <a:spcPts val="75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egulation</a:t>
                      </a:r>
                      <a:r>
                        <a:rPr sz="110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eed</a:t>
                      </a:r>
                      <a:r>
                        <a:rPr sz="11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growth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58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BCD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0566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1E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350">
                        <a:latin typeface="Times New Roman"/>
                        <a:cs typeface="Times New Roman"/>
                      </a:endParaRPr>
                    </a:p>
                    <a:p>
                      <a:pPr marL="164465" marR="166370" indent="59055">
                        <a:lnSpc>
                          <a:spcPct val="120000"/>
                        </a:lnSpc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hloem  transpo</a:t>
                      </a:r>
                      <a:r>
                        <a:rPr sz="1100" b="1" spc="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NADH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65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oxid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U1</a:t>
                      </a:r>
                      <a:r>
                        <a:rPr sz="11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snRNA</a:t>
                      </a:r>
                      <a:endParaRPr sz="1100">
                        <a:latin typeface="Arial"/>
                        <a:cs typeface="Arial"/>
                      </a:endParaRPr>
                    </a:p>
                    <a:p>
                      <a:pPr marL="73025" marR="65405" indent="-635" algn="ctr">
                        <a:lnSpc>
                          <a:spcPct val="12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3−end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100" b="1" spc="-2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cessing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39370" marR="31750" indent="-635" algn="ctr">
                        <a:lnSpc>
                          <a:spcPct val="123700"/>
                        </a:lnSpc>
                        <a:spcBef>
                          <a:spcPts val="5"/>
                        </a:spcBef>
                      </a:pPr>
                      <a:r>
                        <a:rPr sz="800" b="1" spc="-10" dirty="0">
                          <a:latin typeface="Arial"/>
                          <a:cs typeface="Arial"/>
                        </a:rPr>
                        <a:t>glycine  </a:t>
                      </a:r>
                      <a:r>
                        <a:rPr sz="800" b="1" dirty="0">
                          <a:latin typeface="Arial"/>
                          <a:cs typeface="Arial"/>
                        </a:rPr>
                        <a:t>decarb</a:t>
                      </a:r>
                      <a:r>
                        <a:rPr sz="800" b="1" spc="-2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xylation  via </a:t>
                      </a:r>
                      <a:r>
                        <a:rPr sz="800" b="1" spc="-10" dirty="0">
                          <a:latin typeface="Arial"/>
                          <a:cs typeface="Arial"/>
                        </a:rPr>
                        <a:t>glycine  cleavage</a:t>
                      </a:r>
                      <a:r>
                        <a:rPr sz="8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800" b="1" spc="-5" dirty="0">
                          <a:latin typeface="Arial"/>
                          <a:cs typeface="Arial"/>
                        </a:rPr>
                        <a:t>system</a:t>
                      </a:r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86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17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0A6C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5800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1E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4">
                  <a:txBody>
                    <a:bodyPr/>
                    <a:lstStyle/>
                    <a:p>
                      <a:pPr marL="28575" marR="20320" indent="-635" algn="ctr">
                        <a:lnSpc>
                          <a:spcPct val="120000"/>
                        </a:lnSpc>
                        <a:spcBef>
                          <a:spcPts val="270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thylakoid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embrane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anization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342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gridSpan="4">
                  <a:txBody>
                    <a:bodyPr/>
                    <a:lstStyle/>
                    <a:p>
                      <a:pPr marL="40640" marR="33655" algn="ctr">
                        <a:lnSpc>
                          <a:spcPct val="120000"/>
                        </a:lnSpc>
                        <a:spcBef>
                          <a:spcPts val="420"/>
                        </a:spcBef>
                      </a:pPr>
                      <a:r>
                        <a:rPr sz="11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sponse</a:t>
                      </a:r>
                      <a:r>
                        <a:rPr sz="1100" b="1" spc="-9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o  high light  intensity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5334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98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28575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47828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287E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656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1E3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127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DBE9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F9F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19050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E5E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715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A3A3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35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28575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FFDBDB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34290" marB="0">
                    <a:lnL w="28575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4790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334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3887FF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4">
                  <a:txBody>
                    <a:bodyPr/>
                    <a:lstStyle/>
                    <a:p>
                      <a:pPr marL="374650" marR="133350" indent="-234315">
                        <a:lnSpc>
                          <a:spcPct val="120000"/>
                        </a:lnSpc>
                        <a:spcBef>
                          <a:spcPts val="12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rRNA</a:t>
                      </a:r>
                      <a:r>
                        <a:rPr sz="1100" b="1" spc="-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catabolic  process</a:t>
                      </a:r>
                      <a:endParaRPr sz="1100">
                        <a:latin typeface="Arial"/>
                        <a:cs typeface="Arial"/>
                      </a:endParaRPr>
                    </a:p>
                  </a:txBody>
                  <a:tcPr marL="0" marR="0" marT="15240" marB="0">
                    <a:lnL w="19050">
                      <a:solidFill>
                        <a:srgbClr val="000000"/>
                      </a:solidFill>
                      <a:prstDash val="solid"/>
                    </a:lnL>
                    <a:lnR w="19050">
                      <a:solidFill>
                        <a:srgbClr val="000000"/>
                      </a:solidFill>
                      <a:prstDash val="solid"/>
                    </a:lnR>
                    <a:lnT w="28575">
                      <a:solidFill>
                        <a:srgbClr val="000000"/>
                      </a:solidFill>
                      <a:prstDash val="solid"/>
                    </a:lnT>
                    <a:lnB w="19050">
                      <a:solidFill>
                        <a:srgbClr val="000000"/>
                      </a:solidFill>
                      <a:prstDash val="solid"/>
                    </a:lnB>
                    <a:solidFill>
                      <a:srgbClr val="C6DD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</a:tbl>
          </a:graphicData>
        </a:graphic>
      </p:graphicFrame>
      <p:sp>
        <p:nvSpPr>
          <p:cNvPr id="17" name="Rettangolo 16"/>
          <p:cNvSpPr/>
          <p:nvPr/>
        </p:nvSpPr>
        <p:spPr>
          <a:xfrm>
            <a:off x="407282" y="8491674"/>
            <a:ext cx="13815836" cy="503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emap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ing the results of the Gene Ontology Enrichment Analysis performed on the genes classified as “Low” (A), “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w_Mi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B), “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d_High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C) and “High” (D). Each box represents a biological process. The box size reflects the -log10 FDR of the GO term. The color of the boxes reflects the enrichment score of the GO category from the lowest (blue) to the highest (red).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ttangolo 17"/>
          <p:cNvSpPr/>
          <p:nvPr/>
        </p:nvSpPr>
        <p:spPr>
          <a:xfrm>
            <a:off x="12725400" y="7994523"/>
            <a:ext cx="2590800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D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DAF27E465E9D544BA6E456B7694FCBD" ma:contentTypeVersion="13" ma:contentTypeDescription="Creare un nuovo documento." ma:contentTypeScope="" ma:versionID="fe8124e4c94682e6a433aeaf1fd84dc0">
  <xsd:schema xmlns:xsd="http://www.w3.org/2001/XMLSchema" xmlns:xs="http://www.w3.org/2001/XMLSchema" xmlns:p="http://schemas.microsoft.com/office/2006/metadata/properties" xmlns:ns3="c7cae103-93ad-4c93-a5ef-67d5c5e21413" xmlns:ns4="d98f46d9-7d05-4798-ad0b-6df40240d227" targetNamespace="http://schemas.microsoft.com/office/2006/metadata/properties" ma:root="true" ma:fieldsID="bf6736f76d33aefcf40cd35bb86e24e2" ns3:_="" ns4:_="">
    <xsd:import namespace="c7cae103-93ad-4c93-a5ef-67d5c5e21413"/>
    <xsd:import namespace="d98f46d9-7d05-4798-ad0b-6df40240d22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ae103-93ad-4c93-a5ef-67d5c5e21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f46d9-7d05-4798-ad0b-6df40240d227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7BFF02C-DF3C-4459-8092-4DCD70544AF7}">
  <ds:schemaRefs>
    <ds:schemaRef ds:uri="http://purl.org/dc/elements/1.1/"/>
    <ds:schemaRef ds:uri="http://purl.org/dc/terms/"/>
    <ds:schemaRef ds:uri="c7cae103-93ad-4c93-a5ef-67d5c5e21413"/>
    <ds:schemaRef ds:uri="http://www.w3.org/XML/1998/namespace"/>
    <ds:schemaRef ds:uri="http://schemas.openxmlformats.org/package/2006/metadata/core-properties"/>
    <ds:schemaRef ds:uri="http://purl.org/dc/dcmitype/"/>
    <ds:schemaRef ds:uri="http://schemas.microsoft.com/office/2006/metadata/properties"/>
    <ds:schemaRef ds:uri="d98f46d9-7d05-4798-ad0b-6df40240d227"/>
    <ds:schemaRef ds:uri="http://schemas.microsoft.com/office/infopath/2007/PartnerControls"/>
    <ds:schemaRef ds:uri="http://schemas.microsoft.com/office/2006/documentManagement/types"/>
  </ds:schemaRefs>
</ds:datastoreItem>
</file>

<file path=customXml/itemProps2.xml><?xml version="1.0" encoding="utf-8"?>
<ds:datastoreItem xmlns:ds="http://schemas.openxmlformats.org/officeDocument/2006/customXml" ds:itemID="{56C11803-18AC-4A19-AF5D-8405B81E3C9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87ABB8-9142-4DC9-B272-BBF34D17C5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ae103-93ad-4c93-a5ef-67d5c5e21413"/>
    <ds:schemaRef ds:uri="d98f46d9-7d05-4798-ad0b-6df40240d2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Words>1485</Words>
  <Application>Microsoft Office PowerPoint</Application>
  <PresentationFormat>Personalizzato</PresentationFormat>
  <Paragraphs>943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ermolino</dc:creator>
  <cp:lastModifiedBy>Clara Conicella</cp:lastModifiedBy>
  <cp:revision>11</cp:revision>
  <dcterms:created xsi:type="dcterms:W3CDTF">2020-12-04T10:14:17Z</dcterms:created>
  <dcterms:modified xsi:type="dcterms:W3CDTF">2021-01-22T19:0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0-12-04T00:00:00Z</vt:filetime>
  </property>
  <property fmtid="{D5CDD505-2E9C-101B-9397-08002B2CF9AE}" pid="3" name="ContentTypeId">
    <vt:lpwstr>0x010100ADAF27E465E9D544BA6E456B7694FCBD</vt:lpwstr>
  </property>
</Properties>
</file>